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058400" cy="7772400"/>
  <p:notesSz cx="6858000" cy="9144000"/>
  <p:defaultTextStyle>
    <a:defPPr>
      <a:defRPr lang="en-US"/>
    </a:defPPr>
    <a:lvl1pPr marL="0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509412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3" d="100"/>
          <a:sy n="133" d="100"/>
        </p:scale>
        <p:origin x="-112" y="-928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3486641-08D6-BB44-86D7-DD7EF297090A}" type="doc">
      <dgm:prSet loTypeId="urn:microsoft.com/office/officeart/2005/8/layout/hierarchy3" loCatId="" qsTypeId="urn:microsoft.com/office/officeart/2005/8/quickstyle/simple4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49A4CC4B-F1F8-9243-9DC8-977908927EEF}">
      <dgm:prSet phldrT="[Text]" custT="1"/>
      <dgm:spPr/>
      <dgm:t>
        <a:bodyPr/>
        <a:lstStyle/>
        <a:p>
          <a:r>
            <a:rPr lang="en-US" sz="1400" dirty="0" smtClean="0">
              <a:solidFill>
                <a:schemeClr val="tx1"/>
              </a:solidFill>
            </a:rPr>
            <a:t>1. Identify EMMA intervention activities</a:t>
          </a:r>
          <a:endParaRPr lang="en-US" sz="1400" dirty="0">
            <a:solidFill>
              <a:schemeClr val="tx1"/>
            </a:solidFill>
          </a:endParaRPr>
        </a:p>
      </dgm:t>
    </dgm:pt>
    <dgm:pt modelId="{66131FCE-E483-9544-8361-A5B82051B25F}" type="parTrans" cxnId="{FCC5CF16-7E12-8A48-B211-E8A641785AC7}">
      <dgm:prSet/>
      <dgm:spPr/>
      <dgm:t>
        <a:bodyPr/>
        <a:lstStyle/>
        <a:p>
          <a:endParaRPr lang="en-US"/>
        </a:p>
      </dgm:t>
    </dgm:pt>
    <dgm:pt modelId="{68367F81-D3CF-FE40-9450-70D9EFD8740B}" type="sibTrans" cxnId="{FCC5CF16-7E12-8A48-B211-E8A641785AC7}">
      <dgm:prSet/>
      <dgm:spPr/>
      <dgm:t>
        <a:bodyPr/>
        <a:lstStyle/>
        <a:p>
          <a:endParaRPr lang="en-US"/>
        </a:p>
      </dgm:t>
    </dgm:pt>
    <dgm:pt modelId="{2D17E121-C6E3-3B4E-9F39-43D133BE1348}">
      <dgm:prSet phldrT="[Text]" custT="1"/>
      <dgm:spPr/>
      <dgm:t>
        <a:bodyPr/>
        <a:lstStyle/>
        <a:p>
          <a:r>
            <a:rPr lang="en-US" sz="1000" dirty="0" smtClean="0"/>
            <a:t>a. Train Mother Mentors (MMs) and Supervisors (all sites)</a:t>
          </a:r>
          <a:endParaRPr lang="en-US" sz="1000" dirty="0"/>
        </a:p>
      </dgm:t>
    </dgm:pt>
    <dgm:pt modelId="{029F9BB8-423E-5E4D-B120-C84233D4E844}" type="parTrans" cxnId="{828AB0C9-4AD2-4F41-B69C-16C8590F8181}">
      <dgm:prSet/>
      <dgm:spPr/>
      <dgm:t>
        <a:bodyPr/>
        <a:lstStyle/>
        <a:p>
          <a:endParaRPr lang="en-US"/>
        </a:p>
      </dgm:t>
    </dgm:pt>
    <dgm:pt modelId="{EBBD09C8-0B6F-FA45-9324-E67B66118F0C}" type="sibTrans" cxnId="{828AB0C9-4AD2-4F41-B69C-16C8590F8181}">
      <dgm:prSet/>
      <dgm:spPr/>
      <dgm:t>
        <a:bodyPr/>
        <a:lstStyle/>
        <a:p>
          <a:endParaRPr lang="en-US"/>
        </a:p>
      </dgm:t>
    </dgm:pt>
    <dgm:pt modelId="{D8E06292-CAA4-E04A-97EA-9BE72EC3D7ED}">
      <dgm:prSet phldrT="[Text]"/>
      <dgm:spPr/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2. Estimate costs for each activity</a:t>
          </a:r>
          <a:endParaRPr lang="en-US" dirty="0">
            <a:solidFill>
              <a:schemeClr val="tx1"/>
            </a:solidFill>
          </a:endParaRPr>
        </a:p>
      </dgm:t>
    </dgm:pt>
    <dgm:pt modelId="{E18B0DF2-8BE4-674C-A03C-3A3C31B9BE9F}" type="parTrans" cxnId="{4DBDCD7A-3405-094F-B572-1DBA92C7D5E8}">
      <dgm:prSet/>
      <dgm:spPr/>
      <dgm:t>
        <a:bodyPr/>
        <a:lstStyle/>
        <a:p>
          <a:endParaRPr lang="en-US"/>
        </a:p>
      </dgm:t>
    </dgm:pt>
    <dgm:pt modelId="{1F939C9F-4624-D147-8C1D-624713BF7DB7}" type="sibTrans" cxnId="{4DBDCD7A-3405-094F-B572-1DBA92C7D5E8}">
      <dgm:prSet/>
      <dgm:spPr/>
      <dgm:t>
        <a:bodyPr/>
        <a:lstStyle/>
        <a:p>
          <a:endParaRPr lang="en-US"/>
        </a:p>
      </dgm:t>
    </dgm:pt>
    <dgm:pt modelId="{9DCCF5E4-AFF2-484B-9474-3158221EE852}">
      <dgm:prSet phldrT="[Text]" custT="1"/>
      <dgm:spPr/>
      <dgm:t>
        <a:bodyPr/>
        <a:lstStyle/>
        <a:p>
          <a:r>
            <a:rPr lang="en-US" sz="1000" dirty="0" smtClean="0"/>
            <a:t>a. Upfront cost for trainings (training expenditures, labor for trainers, etc.) </a:t>
          </a:r>
          <a:endParaRPr lang="en-US" sz="1000" dirty="0"/>
        </a:p>
      </dgm:t>
    </dgm:pt>
    <dgm:pt modelId="{971FF5C4-01E5-C044-8273-63D872A89BE1}" type="parTrans" cxnId="{5505FA5E-C2A9-7040-B28F-8A6F9EA06CE9}">
      <dgm:prSet/>
      <dgm:spPr/>
      <dgm:t>
        <a:bodyPr/>
        <a:lstStyle/>
        <a:p>
          <a:endParaRPr lang="en-US"/>
        </a:p>
      </dgm:t>
    </dgm:pt>
    <dgm:pt modelId="{0DAF8392-B31C-4D42-BCB4-92EF762BD21D}" type="sibTrans" cxnId="{5505FA5E-C2A9-7040-B28F-8A6F9EA06CE9}">
      <dgm:prSet/>
      <dgm:spPr/>
      <dgm:t>
        <a:bodyPr/>
        <a:lstStyle/>
        <a:p>
          <a:endParaRPr lang="en-US"/>
        </a:p>
      </dgm:t>
    </dgm:pt>
    <dgm:pt modelId="{81A75B0B-6277-EA41-B4A0-D272273B6519}">
      <dgm:prSet phldrT="[Text]" custT="1"/>
      <dgm:spPr/>
      <dgm:t>
        <a:bodyPr/>
        <a:lstStyle/>
        <a:p>
          <a:r>
            <a:rPr lang="en-US" sz="1000" dirty="0" smtClean="0"/>
            <a:t>b. Any up front cost for organizing space (renovations). Information from program records. </a:t>
          </a:r>
          <a:endParaRPr lang="en-US" sz="1000" dirty="0"/>
        </a:p>
      </dgm:t>
    </dgm:pt>
    <dgm:pt modelId="{AE534E73-15B3-6B4C-B71D-B94FD7888D77}" type="parTrans" cxnId="{147BFBB0-AE01-6D4B-88EB-99F61D8CC122}">
      <dgm:prSet/>
      <dgm:spPr/>
      <dgm:t>
        <a:bodyPr/>
        <a:lstStyle/>
        <a:p>
          <a:endParaRPr lang="en-US"/>
        </a:p>
      </dgm:t>
    </dgm:pt>
    <dgm:pt modelId="{E3B44061-4E24-A148-A211-BE31F700B820}" type="sibTrans" cxnId="{147BFBB0-AE01-6D4B-88EB-99F61D8CC122}">
      <dgm:prSet/>
      <dgm:spPr/>
      <dgm:t>
        <a:bodyPr/>
        <a:lstStyle/>
        <a:p>
          <a:endParaRPr lang="en-US"/>
        </a:p>
      </dgm:t>
    </dgm:pt>
    <dgm:pt modelId="{B24E0B99-7158-734C-B57A-397221519A5F}">
      <dgm:prSet custT="1"/>
      <dgm:spPr/>
      <dgm:t>
        <a:bodyPr/>
        <a:lstStyle/>
        <a:p>
          <a:r>
            <a:rPr lang="en-US" sz="1000" dirty="0" smtClean="0"/>
            <a:t>b. Organize space for exit visit with mother (only EMMA sites)</a:t>
          </a:r>
          <a:endParaRPr lang="en-US" sz="1000" dirty="0"/>
        </a:p>
      </dgm:t>
    </dgm:pt>
    <dgm:pt modelId="{31E54F99-F707-6D4C-B272-8106A5F56A45}" type="parTrans" cxnId="{EE1C0397-D064-1249-BE66-A626F81767E4}">
      <dgm:prSet/>
      <dgm:spPr/>
      <dgm:t>
        <a:bodyPr/>
        <a:lstStyle/>
        <a:p>
          <a:endParaRPr lang="en-US"/>
        </a:p>
      </dgm:t>
    </dgm:pt>
    <dgm:pt modelId="{89489314-66F9-0548-8D25-DC763A39243C}" type="sibTrans" cxnId="{EE1C0397-D064-1249-BE66-A626F81767E4}">
      <dgm:prSet/>
      <dgm:spPr/>
      <dgm:t>
        <a:bodyPr/>
        <a:lstStyle/>
        <a:p>
          <a:endParaRPr lang="en-US"/>
        </a:p>
      </dgm:t>
    </dgm:pt>
    <dgm:pt modelId="{FA0C812A-09BB-D843-8229-203E5F468885}">
      <dgm:prSet custT="1"/>
      <dgm:spPr/>
      <dgm:t>
        <a:bodyPr/>
        <a:lstStyle/>
        <a:p>
          <a:r>
            <a:rPr lang="en-US" sz="1000" dirty="0" smtClean="0"/>
            <a:t>c. Any up front costs for technology.  Information from program records.  </a:t>
          </a:r>
          <a:endParaRPr lang="en-US" sz="1000" dirty="0"/>
        </a:p>
      </dgm:t>
    </dgm:pt>
    <dgm:pt modelId="{CA7D790B-19FC-5149-9599-243F05F23FC6}" type="parTrans" cxnId="{26C0B56A-56F9-2E4F-A0CA-CC50D858E411}">
      <dgm:prSet/>
      <dgm:spPr/>
      <dgm:t>
        <a:bodyPr/>
        <a:lstStyle/>
        <a:p>
          <a:endParaRPr lang="en-US"/>
        </a:p>
      </dgm:t>
    </dgm:pt>
    <dgm:pt modelId="{917CBE3C-42EC-714C-8C54-99A6FA4C67BC}" type="sibTrans" cxnId="{26C0B56A-56F9-2E4F-A0CA-CC50D858E411}">
      <dgm:prSet/>
      <dgm:spPr/>
      <dgm:t>
        <a:bodyPr/>
        <a:lstStyle/>
        <a:p>
          <a:endParaRPr lang="en-US"/>
        </a:p>
      </dgm:t>
    </dgm:pt>
    <dgm:pt modelId="{0AFA9355-AD3C-3442-A7A5-5363B6663959}">
      <dgm:prSet custT="1"/>
      <dgm:spPr/>
      <dgm:t>
        <a:bodyPr/>
        <a:lstStyle/>
        <a:p>
          <a:r>
            <a:rPr lang="en-US" sz="1000" dirty="0" smtClean="0"/>
            <a:t>c. Acquire any needed technology for MM (all sites)</a:t>
          </a:r>
          <a:endParaRPr lang="en-US" sz="1000" dirty="0"/>
        </a:p>
      </dgm:t>
    </dgm:pt>
    <dgm:pt modelId="{5C12194D-DBA3-7043-95AD-E5B6CB0CA537}" type="parTrans" cxnId="{B47A4A1B-3BA1-F548-99EC-12461EC8A52E}">
      <dgm:prSet/>
      <dgm:spPr/>
      <dgm:t>
        <a:bodyPr/>
        <a:lstStyle/>
        <a:p>
          <a:endParaRPr lang="en-US"/>
        </a:p>
      </dgm:t>
    </dgm:pt>
    <dgm:pt modelId="{5F803EFD-D486-EA4A-9564-51FEB532E622}" type="sibTrans" cxnId="{B47A4A1B-3BA1-F548-99EC-12461EC8A52E}">
      <dgm:prSet/>
      <dgm:spPr/>
      <dgm:t>
        <a:bodyPr/>
        <a:lstStyle/>
        <a:p>
          <a:endParaRPr lang="en-US"/>
        </a:p>
      </dgm:t>
    </dgm:pt>
    <dgm:pt modelId="{963860DD-75C3-A04D-A927-C241458B6F3C}">
      <dgm:prSet/>
      <dgm:spPr/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3. Create final costing database </a:t>
          </a:r>
          <a:endParaRPr lang="en-US" dirty="0">
            <a:solidFill>
              <a:schemeClr val="tx1"/>
            </a:solidFill>
          </a:endParaRPr>
        </a:p>
      </dgm:t>
    </dgm:pt>
    <dgm:pt modelId="{773F61A4-5E32-E746-B182-9F1BDAD05480}" type="sibTrans" cxnId="{C22FFC7F-8F2D-0648-BCBD-C749F286F708}">
      <dgm:prSet/>
      <dgm:spPr/>
      <dgm:t>
        <a:bodyPr/>
        <a:lstStyle/>
        <a:p>
          <a:endParaRPr lang="en-US"/>
        </a:p>
      </dgm:t>
    </dgm:pt>
    <dgm:pt modelId="{6D7B02F2-E111-004B-8E5F-412C7F30176F}" type="parTrans" cxnId="{C22FFC7F-8F2D-0648-BCBD-C749F286F708}">
      <dgm:prSet/>
      <dgm:spPr/>
      <dgm:t>
        <a:bodyPr/>
        <a:lstStyle/>
        <a:p>
          <a:endParaRPr lang="en-US"/>
        </a:p>
      </dgm:t>
    </dgm:pt>
    <dgm:pt modelId="{5A2245D1-57D6-334B-8725-052B522D46A0}">
      <dgm:prSet custT="1"/>
      <dgm:spPr/>
      <dgm:t>
        <a:bodyPr/>
        <a:lstStyle/>
        <a:p>
          <a:r>
            <a:rPr lang="en-US" sz="1000" dirty="0" smtClean="0"/>
            <a:t>1. Data/information organized in Excel workbook to estimate cost per activity identified in Step 1/2.</a:t>
          </a:r>
        </a:p>
        <a:p>
          <a:endParaRPr lang="en-US" sz="1000" dirty="0" smtClean="0"/>
        </a:p>
        <a:p>
          <a:r>
            <a:rPr lang="en-US" sz="1000" dirty="0" smtClean="0"/>
            <a:t>With 12 sites (6 intervention/6 control), will have 12 Excel workbooks)</a:t>
          </a:r>
          <a:endParaRPr lang="en-US" sz="1000" dirty="0"/>
        </a:p>
      </dgm:t>
    </dgm:pt>
    <dgm:pt modelId="{2186ADFF-6C6E-D442-9103-38B3AC49A987}" type="parTrans" cxnId="{031CBBC1-B2BD-CF48-A48A-6D8832759B20}">
      <dgm:prSet/>
      <dgm:spPr/>
      <dgm:t>
        <a:bodyPr/>
        <a:lstStyle/>
        <a:p>
          <a:endParaRPr lang="en-US"/>
        </a:p>
      </dgm:t>
    </dgm:pt>
    <dgm:pt modelId="{A6DE2CC7-EF8E-6D49-818C-C6826EABB58F}" type="sibTrans" cxnId="{031CBBC1-B2BD-CF48-A48A-6D8832759B20}">
      <dgm:prSet/>
      <dgm:spPr/>
      <dgm:t>
        <a:bodyPr/>
        <a:lstStyle/>
        <a:p>
          <a:endParaRPr lang="en-US"/>
        </a:p>
      </dgm:t>
    </dgm:pt>
    <dgm:pt modelId="{14E3DAFC-CE71-5147-955D-A330275854D5}">
      <dgm:prSet custT="1"/>
      <dgm:spPr/>
      <dgm:t>
        <a:bodyPr/>
        <a:lstStyle/>
        <a:p>
          <a:r>
            <a:rPr lang="en-US" sz="1000" dirty="0" smtClean="0"/>
            <a:t>d. MM and/or supervisor supplies. Information from program records.  </a:t>
          </a:r>
          <a:endParaRPr lang="en-US" sz="1000" dirty="0"/>
        </a:p>
      </dgm:t>
    </dgm:pt>
    <dgm:pt modelId="{71D0D3AF-13D6-2441-88B4-36E15862C66F}" type="parTrans" cxnId="{10E1ABA9-EFFB-634A-8EB4-8F699A5A1962}">
      <dgm:prSet/>
      <dgm:spPr/>
      <dgm:t>
        <a:bodyPr/>
        <a:lstStyle/>
        <a:p>
          <a:endParaRPr lang="en-US"/>
        </a:p>
      </dgm:t>
    </dgm:pt>
    <dgm:pt modelId="{9F5F98DB-DDDF-D945-BA26-1EF1CC09E196}" type="sibTrans" cxnId="{10E1ABA9-EFFB-634A-8EB4-8F699A5A1962}">
      <dgm:prSet/>
      <dgm:spPr/>
      <dgm:t>
        <a:bodyPr/>
        <a:lstStyle/>
        <a:p>
          <a:endParaRPr lang="en-US"/>
        </a:p>
      </dgm:t>
    </dgm:pt>
    <dgm:pt modelId="{13E8538C-82C2-AA4F-83F1-1F0F937CC84B}">
      <dgm:prSet/>
      <dgm:spPr/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4. Summarize results </a:t>
          </a:r>
          <a:endParaRPr lang="en-US" dirty="0">
            <a:solidFill>
              <a:schemeClr val="tx1"/>
            </a:solidFill>
          </a:endParaRPr>
        </a:p>
      </dgm:t>
    </dgm:pt>
    <dgm:pt modelId="{D612F36E-FB0E-4743-A91E-F05004136286}" type="parTrans" cxnId="{D2CEF025-33D2-C847-8C1F-02CB44166358}">
      <dgm:prSet/>
      <dgm:spPr/>
      <dgm:t>
        <a:bodyPr/>
        <a:lstStyle/>
        <a:p>
          <a:endParaRPr lang="en-US"/>
        </a:p>
      </dgm:t>
    </dgm:pt>
    <dgm:pt modelId="{CFC66188-75BE-0346-8119-E1C9E6DBE760}" type="sibTrans" cxnId="{D2CEF025-33D2-C847-8C1F-02CB44166358}">
      <dgm:prSet/>
      <dgm:spPr/>
      <dgm:t>
        <a:bodyPr/>
        <a:lstStyle/>
        <a:p>
          <a:endParaRPr lang="en-US"/>
        </a:p>
      </dgm:t>
    </dgm:pt>
    <dgm:pt modelId="{F92EFC32-CB7B-BC4D-823B-E21A5D7BECC6}">
      <dgm:prSet custT="1"/>
      <dgm:spPr/>
      <dgm:t>
        <a:bodyPr/>
        <a:lstStyle/>
        <a:p>
          <a:pPr algn="l"/>
          <a:r>
            <a:rPr lang="en-US" sz="1000" dirty="0" smtClean="0"/>
            <a:t>1. Costs per activity (note: units for each activity not identical) for each site.</a:t>
          </a:r>
        </a:p>
        <a:p>
          <a:pPr algn="l"/>
          <a:endParaRPr lang="en-US" sz="1000" dirty="0" smtClean="0"/>
        </a:p>
        <a:p>
          <a:pPr algn="l"/>
          <a:r>
            <a:rPr lang="en-US" sz="1000" dirty="0" smtClean="0"/>
            <a:t>2. Estimated average cost per activity for sites in each study arm.</a:t>
          </a:r>
        </a:p>
        <a:p>
          <a:pPr algn="l"/>
          <a:endParaRPr lang="en-US" sz="1000" dirty="0" smtClean="0"/>
        </a:p>
        <a:p>
          <a:pPr algn="l"/>
          <a:r>
            <a:rPr lang="en-US" sz="1000" dirty="0" smtClean="0"/>
            <a:t>3.  Estimated difference in average costs for two study arms.</a:t>
          </a:r>
        </a:p>
        <a:p>
          <a:pPr algn="l"/>
          <a:endParaRPr lang="en-US" sz="1000" dirty="0" smtClean="0"/>
        </a:p>
        <a:p>
          <a:pPr algn="l"/>
          <a:r>
            <a:rPr lang="en-US" sz="1000" dirty="0" smtClean="0"/>
            <a:t>4.  Results from 3 above is the incremental cost of implementing the EMMMA intervention.</a:t>
          </a:r>
        </a:p>
        <a:p>
          <a:pPr algn="l"/>
          <a:endParaRPr lang="en-US" sz="1000" dirty="0" smtClean="0"/>
        </a:p>
      </dgm:t>
    </dgm:pt>
    <dgm:pt modelId="{D8ECBF77-D655-C346-9222-8D9676561FF4}" type="parTrans" cxnId="{3254FC4D-4548-A649-9019-C0712D04F64A}">
      <dgm:prSet/>
      <dgm:spPr/>
      <dgm:t>
        <a:bodyPr/>
        <a:lstStyle/>
        <a:p>
          <a:endParaRPr lang="en-US"/>
        </a:p>
      </dgm:t>
    </dgm:pt>
    <dgm:pt modelId="{79B52032-CEDF-3F47-A6CA-7547C085E7A3}" type="sibTrans" cxnId="{3254FC4D-4548-A649-9019-C0712D04F64A}">
      <dgm:prSet/>
      <dgm:spPr/>
      <dgm:t>
        <a:bodyPr/>
        <a:lstStyle/>
        <a:p>
          <a:endParaRPr lang="en-US"/>
        </a:p>
      </dgm:t>
    </dgm:pt>
    <dgm:pt modelId="{AC3103BF-ED2F-4AD6-984F-D26B3CC198DA}">
      <dgm:prSet custT="1"/>
      <dgm:spPr/>
      <dgm:t>
        <a:bodyPr/>
        <a:lstStyle/>
        <a:p>
          <a:r>
            <a:rPr lang="en-US" sz="1000" dirty="0" smtClean="0"/>
            <a:t>d. On-going supplies for MMs (all sites)</a:t>
          </a:r>
          <a:endParaRPr lang="en-US" sz="1000" dirty="0"/>
        </a:p>
      </dgm:t>
    </dgm:pt>
    <dgm:pt modelId="{CDBAC1A8-9875-4E34-9519-A34D6B610283}" type="parTrans" cxnId="{CB7B2207-ABE5-47C4-91EC-996D6399EC6F}">
      <dgm:prSet/>
      <dgm:spPr/>
      <dgm:t>
        <a:bodyPr/>
        <a:lstStyle/>
        <a:p>
          <a:endParaRPr lang="en-US"/>
        </a:p>
      </dgm:t>
    </dgm:pt>
    <dgm:pt modelId="{1117BA25-87BA-423B-BFA0-C78708B4AF15}" type="sibTrans" cxnId="{CB7B2207-ABE5-47C4-91EC-996D6399EC6F}">
      <dgm:prSet/>
      <dgm:spPr/>
      <dgm:t>
        <a:bodyPr/>
        <a:lstStyle/>
        <a:p>
          <a:endParaRPr lang="en-US"/>
        </a:p>
      </dgm:t>
    </dgm:pt>
    <dgm:pt modelId="{13D28453-A091-6842-96AF-AAB42DA0EA5D}">
      <dgm:prSet custT="1"/>
      <dgm:spPr/>
      <dgm:t>
        <a:bodyPr/>
        <a:lstStyle/>
        <a:p>
          <a:r>
            <a:rPr lang="en-US" sz="1000" dirty="0" smtClean="0"/>
            <a:t>e. MMs and Supervisors provide routine service activities (all sites)</a:t>
          </a:r>
          <a:endParaRPr lang="en-US" sz="1000" dirty="0"/>
        </a:p>
      </dgm:t>
    </dgm:pt>
    <dgm:pt modelId="{033AC75A-C0AB-1E4A-BF1F-D1116EA64355}" type="parTrans" cxnId="{4AB32705-C73F-C84E-A270-66C610D67F5F}">
      <dgm:prSet/>
      <dgm:spPr/>
      <dgm:t>
        <a:bodyPr/>
        <a:lstStyle/>
        <a:p>
          <a:endParaRPr lang="en-US"/>
        </a:p>
      </dgm:t>
    </dgm:pt>
    <dgm:pt modelId="{167E7A1C-56FD-1F46-AD5E-D5E972E02EDD}" type="sibTrans" cxnId="{4AB32705-C73F-C84E-A270-66C610D67F5F}">
      <dgm:prSet/>
      <dgm:spPr/>
      <dgm:t>
        <a:bodyPr/>
        <a:lstStyle/>
        <a:p>
          <a:endParaRPr lang="en-US"/>
        </a:p>
      </dgm:t>
    </dgm:pt>
    <dgm:pt modelId="{555B88C6-1EC4-B044-A582-FF943C32DE05}">
      <dgm:prSet custT="1"/>
      <dgm:spPr/>
      <dgm:t>
        <a:bodyPr/>
        <a:lstStyle/>
        <a:p>
          <a:r>
            <a:rPr lang="en-US" sz="1000" dirty="0" smtClean="0"/>
            <a:t>e. MM and supervisor labor and any additional supplies/activities not included above.  Information from program records.</a:t>
          </a:r>
          <a:endParaRPr lang="en-US" sz="1000" dirty="0"/>
        </a:p>
      </dgm:t>
    </dgm:pt>
    <dgm:pt modelId="{41D0A532-0EAE-CD4A-B789-CB3652F00DC2}" type="parTrans" cxnId="{DCB08E58-1F9E-4E40-B5C8-7562B3B9AA5A}">
      <dgm:prSet/>
      <dgm:spPr/>
      <dgm:t>
        <a:bodyPr/>
        <a:lstStyle/>
        <a:p>
          <a:endParaRPr lang="en-US"/>
        </a:p>
      </dgm:t>
    </dgm:pt>
    <dgm:pt modelId="{3FF66635-E62B-4A40-8032-0B7AECB67AA1}" type="sibTrans" cxnId="{DCB08E58-1F9E-4E40-B5C8-7562B3B9AA5A}">
      <dgm:prSet/>
      <dgm:spPr/>
      <dgm:t>
        <a:bodyPr/>
        <a:lstStyle/>
        <a:p>
          <a:endParaRPr lang="en-US"/>
        </a:p>
      </dgm:t>
    </dgm:pt>
    <dgm:pt modelId="{C004C2A9-2C90-9B41-988E-F050F5BC880D}" type="pres">
      <dgm:prSet presAssocID="{33486641-08D6-BB44-86D7-DD7EF297090A}" presName="diagram" presStyleCnt="0">
        <dgm:presLayoutVars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EBFFA279-618E-A649-A6A7-F7172E4C5679}" type="pres">
      <dgm:prSet presAssocID="{49A4CC4B-F1F8-9243-9DC8-977908927EEF}" presName="root" presStyleCnt="0"/>
      <dgm:spPr/>
    </dgm:pt>
    <dgm:pt modelId="{729ED895-7ABF-0E4F-A5CA-6387061ED964}" type="pres">
      <dgm:prSet presAssocID="{49A4CC4B-F1F8-9243-9DC8-977908927EEF}" presName="rootComposite" presStyleCnt="0"/>
      <dgm:spPr/>
    </dgm:pt>
    <dgm:pt modelId="{94A5071D-E87E-3F48-97FC-EEDF62B6BB25}" type="pres">
      <dgm:prSet presAssocID="{49A4CC4B-F1F8-9243-9DC8-977908927EEF}" presName="rootText" presStyleLbl="node1" presStyleIdx="0" presStyleCnt="4" custScaleX="150787" custScaleY="80423"/>
      <dgm:spPr/>
      <dgm:t>
        <a:bodyPr/>
        <a:lstStyle/>
        <a:p>
          <a:endParaRPr lang="en-US"/>
        </a:p>
      </dgm:t>
    </dgm:pt>
    <dgm:pt modelId="{64738EAF-F13B-6E40-9EF4-FB248F1A7EDA}" type="pres">
      <dgm:prSet presAssocID="{49A4CC4B-F1F8-9243-9DC8-977908927EEF}" presName="rootConnector" presStyleLbl="node1" presStyleIdx="0" presStyleCnt="4"/>
      <dgm:spPr/>
      <dgm:t>
        <a:bodyPr/>
        <a:lstStyle/>
        <a:p>
          <a:endParaRPr lang="en-US"/>
        </a:p>
      </dgm:t>
    </dgm:pt>
    <dgm:pt modelId="{05414C9E-5216-D64D-8920-61BC7FBBDF5C}" type="pres">
      <dgm:prSet presAssocID="{49A4CC4B-F1F8-9243-9DC8-977908927EEF}" presName="childShape" presStyleCnt="0"/>
      <dgm:spPr/>
    </dgm:pt>
    <dgm:pt modelId="{CFA2FF03-5E02-2247-A6FA-5F40E097B375}" type="pres">
      <dgm:prSet presAssocID="{029F9BB8-423E-5E4D-B120-C84233D4E844}" presName="Name13" presStyleLbl="parChTrans1D2" presStyleIdx="0" presStyleCnt="12"/>
      <dgm:spPr/>
      <dgm:t>
        <a:bodyPr/>
        <a:lstStyle/>
        <a:p>
          <a:endParaRPr lang="en-US"/>
        </a:p>
      </dgm:t>
    </dgm:pt>
    <dgm:pt modelId="{48BB2E1E-E7E2-C04E-AC65-448851DF6121}" type="pres">
      <dgm:prSet presAssocID="{2D17E121-C6E3-3B4E-9F39-43D133BE1348}" presName="childText" presStyleLbl="bgAcc1" presStyleIdx="0" presStyleCnt="12" custScaleX="16314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409D2DF8-AB56-7A4A-9BDA-7C8A7AFD3BC4}" type="pres">
      <dgm:prSet presAssocID="{31E54F99-F707-6D4C-B272-8106A5F56A45}" presName="Name13" presStyleLbl="parChTrans1D2" presStyleIdx="1" presStyleCnt="12"/>
      <dgm:spPr/>
      <dgm:t>
        <a:bodyPr/>
        <a:lstStyle/>
        <a:p>
          <a:endParaRPr lang="en-US"/>
        </a:p>
      </dgm:t>
    </dgm:pt>
    <dgm:pt modelId="{2F6C24A4-7B08-6D4C-A6B2-7105D71A78BF}" type="pres">
      <dgm:prSet presAssocID="{B24E0B99-7158-734C-B57A-397221519A5F}" presName="childText" presStyleLbl="bgAcc1" presStyleIdx="1" presStyleCnt="12" custScaleX="17469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3030BE9-41EF-7B4C-833E-A4DB457C8CDA}" type="pres">
      <dgm:prSet presAssocID="{5C12194D-DBA3-7043-95AD-E5B6CB0CA537}" presName="Name13" presStyleLbl="parChTrans1D2" presStyleIdx="2" presStyleCnt="12"/>
      <dgm:spPr/>
      <dgm:t>
        <a:bodyPr/>
        <a:lstStyle/>
        <a:p>
          <a:endParaRPr lang="en-US"/>
        </a:p>
      </dgm:t>
    </dgm:pt>
    <dgm:pt modelId="{729C8DBA-3E59-624C-B017-6AE52DA0554A}" type="pres">
      <dgm:prSet presAssocID="{0AFA9355-AD3C-3442-A7A5-5363B6663959}" presName="childText" presStyleLbl="bgAcc1" presStyleIdx="2" presStyleCnt="12" custScaleX="179316" custScaleY="161561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EC73E89-6E20-4C32-A35B-3837FE7DDDC9}" type="pres">
      <dgm:prSet presAssocID="{CDBAC1A8-9875-4E34-9519-A34D6B610283}" presName="Name13" presStyleLbl="parChTrans1D2" presStyleIdx="3" presStyleCnt="12"/>
      <dgm:spPr/>
      <dgm:t>
        <a:bodyPr/>
        <a:lstStyle/>
        <a:p>
          <a:endParaRPr lang="en-US"/>
        </a:p>
      </dgm:t>
    </dgm:pt>
    <dgm:pt modelId="{3A4250D4-BCFC-4F02-91C6-FC6809063146}" type="pres">
      <dgm:prSet presAssocID="{AC3103BF-ED2F-4AD6-984F-D26B3CC198DA}" presName="childText" presStyleLbl="bgAcc1" presStyleIdx="3" presStyleCnt="12" custScaleX="16205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0585FAD-6B7F-0842-B28E-27488CB988F9}" type="pres">
      <dgm:prSet presAssocID="{033AC75A-C0AB-1E4A-BF1F-D1116EA64355}" presName="Name13" presStyleLbl="parChTrans1D2" presStyleIdx="4" presStyleCnt="12"/>
      <dgm:spPr/>
      <dgm:t>
        <a:bodyPr/>
        <a:lstStyle/>
        <a:p>
          <a:endParaRPr lang="en-US"/>
        </a:p>
      </dgm:t>
    </dgm:pt>
    <dgm:pt modelId="{CD58BF61-E173-834C-9C3A-78CC0740BFE8}" type="pres">
      <dgm:prSet presAssocID="{13D28453-A091-6842-96AF-AAB42DA0EA5D}" presName="childText" presStyleLbl="bgAcc1" presStyleIdx="4" presStyleCnt="12" custScaleX="18284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31565AA-D496-2247-9D82-6C5B9AB61014}" type="pres">
      <dgm:prSet presAssocID="{D8E06292-CAA4-E04A-97EA-9BE72EC3D7ED}" presName="root" presStyleCnt="0"/>
      <dgm:spPr/>
    </dgm:pt>
    <dgm:pt modelId="{DF03C3C1-2FD8-374A-8533-04456DCA8D93}" type="pres">
      <dgm:prSet presAssocID="{D8E06292-CAA4-E04A-97EA-9BE72EC3D7ED}" presName="rootComposite" presStyleCnt="0"/>
      <dgm:spPr/>
    </dgm:pt>
    <dgm:pt modelId="{9A612BA4-470B-104D-A211-43EC4F26331B}" type="pres">
      <dgm:prSet presAssocID="{D8E06292-CAA4-E04A-97EA-9BE72EC3D7ED}" presName="rootText" presStyleLbl="node1" presStyleIdx="1" presStyleCnt="4"/>
      <dgm:spPr/>
      <dgm:t>
        <a:bodyPr/>
        <a:lstStyle/>
        <a:p>
          <a:endParaRPr lang="en-US"/>
        </a:p>
      </dgm:t>
    </dgm:pt>
    <dgm:pt modelId="{4AF55A52-1DB8-8C40-B49B-DF4BC4452D80}" type="pres">
      <dgm:prSet presAssocID="{D8E06292-CAA4-E04A-97EA-9BE72EC3D7ED}" presName="rootConnector" presStyleLbl="node1" presStyleIdx="1" presStyleCnt="4"/>
      <dgm:spPr/>
      <dgm:t>
        <a:bodyPr/>
        <a:lstStyle/>
        <a:p>
          <a:endParaRPr lang="en-US"/>
        </a:p>
      </dgm:t>
    </dgm:pt>
    <dgm:pt modelId="{6A2F78E1-C6B0-5241-845A-26ADF1867596}" type="pres">
      <dgm:prSet presAssocID="{D8E06292-CAA4-E04A-97EA-9BE72EC3D7ED}" presName="childShape" presStyleCnt="0"/>
      <dgm:spPr/>
    </dgm:pt>
    <dgm:pt modelId="{C86D4C91-F832-0544-8E40-408CDB1BD0FE}" type="pres">
      <dgm:prSet presAssocID="{971FF5C4-01E5-C044-8273-63D872A89BE1}" presName="Name13" presStyleLbl="parChTrans1D2" presStyleIdx="5" presStyleCnt="12"/>
      <dgm:spPr/>
      <dgm:t>
        <a:bodyPr/>
        <a:lstStyle/>
        <a:p>
          <a:endParaRPr lang="en-US"/>
        </a:p>
      </dgm:t>
    </dgm:pt>
    <dgm:pt modelId="{BBD6F990-7533-094E-BD4F-577B4751F3B0}" type="pres">
      <dgm:prSet presAssocID="{9DCCF5E4-AFF2-484B-9474-3158221EE852}" presName="childText" presStyleLbl="bgAcc1" presStyleIdx="5" presStyleCnt="12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F859DD4-E5EA-2341-917D-7C036D3F7456}" type="pres">
      <dgm:prSet presAssocID="{AE534E73-15B3-6B4C-B71D-B94FD7888D77}" presName="Name13" presStyleLbl="parChTrans1D2" presStyleIdx="6" presStyleCnt="12"/>
      <dgm:spPr/>
      <dgm:t>
        <a:bodyPr/>
        <a:lstStyle/>
        <a:p>
          <a:endParaRPr lang="en-US"/>
        </a:p>
      </dgm:t>
    </dgm:pt>
    <dgm:pt modelId="{6EFFD289-B693-B346-A918-E91A6BB0D027}" type="pres">
      <dgm:prSet presAssocID="{81A75B0B-6277-EA41-B4A0-D272273B6519}" presName="childText" presStyleLbl="bgAcc1" presStyleIdx="6" presStyleCnt="12" custScaleY="15408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F514985B-8F89-3E40-A9D7-AAE0741148EB}" type="pres">
      <dgm:prSet presAssocID="{CA7D790B-19FC-5149-9599-243F05F23FC6}" presName="Name13" presStyleLbl="parChTrans1D2" presStyleIdx="7" presStyleCnt="12"/>
      <dgm:spPr/>
      <dgm:t>
        <a:bodyPr/>
        <a:lstStyle/>
        <a:p>
          <a:endParaRPr lang="en-US"/>
        </a:p>
      </dgm:t>
    </dgm:pt>
    <dgm:pt modelId="{38F3191D-4F4C-B346-9CC0-DE14BF92C87E}" type="pres">
      <dgm:prSet presAssocID="{FA0C812A-09BB-D843-8229-203E5F468885}" presName="childText" presStyleLbl="bgAcc1" presStyleIdx="7" presStyleCnt="12" custScaleY="124431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4A67B95-88B5-D945-A704-EC2CA0DBD6D0}" type="pres">
      <dgm:prSet presAssocID="{71D0D3AF-13D6-2441-88B4-36E15862C66F}" presName="Name13" presStyleLbl="parChTrans1D2" presStyleIdx="8" presStyleCnt="12"/>
      <dgm:spPr/>
      <dgm:t>
        <a:bodyPr/>
        <a:lstStyle/>
        <a:p>
          <a:endParaRPr lang="en-US"/>
        </a:p>
      </dgm:t>
    </dgm:pt>
    <dgm:pt modelId="{9DDB4C29-ED3F-EF44-8E3E-8512077A4EE2}" type="pres">
      <dgm:prSet presAssocID="{14E3DAFC-CE71-5147-955D-A330275854D5}" presName="childText" presStyleLbl="bgAcc1" presStyleIdx="8" presStyleCnt="12" custScaleX="217800" custScaleY="16669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7EF5D09-D349-7747-B40E-22C22407BDA5}" type="pres">
      <dgm:prSet presAssocID="{41D0A532-0EAE-CD4A-B789-CB3652F00DC2}" presName="Name13" presStyleLbl="parChTrans1D2" presStyleIdx="9" presStyleCnt="12"/>
      <dgm:spPr/>
      <dgm:t>
        <a:bodyPr/>
        <a:lstStyle/>
        <a:p>
          <a:endParaRPr lang="en-US"/>
        </a:p>
      </dgm:t>
    </dgm:pt>
    <dgm:pt modelId="{7D8DDBCB-1F4F-F841-9C74-8CDAB5C7900A}" type="pres">
      <dgm:prSet presAssocID="{555B88C6-1EC4-B044-A582-FF943C32DE05}" presName="childText" presStyleLbl="bgAcc1" presStyleIdx="9" presStyleCnt="12" custScaleX="229509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CAD5CFE-7D02-1747-94C3-56C47AEB86A7}" type="pres">
      <dgm:prSet presAssocID="{963860DD-75C3-A04D-A927-C241458B6F3C}" presName="root" presStyleCnt="0"/>
      <dgm:spPr/>
    </dgm:pt>
    <dgm:pt modelId="{4AFF09CE-F42A-2647-AFFE-42B5C37ECE3D}" type="pres">
      <dgm:prSet presAssocID="{963860DD-75C3-A04D-A927-C241458B6F3C}" presName="rootComposite" presStyleCnt="0"/>
      <dgm:spPr/>
    </dgm:pt>
    <dgm:pt modelId="{18D50664-5D57-6B47-A4A5-3F64BC291717}" type="pres">
      <dgm:prSet presAssocID="{963860DD-75C3-A04D-A927-C241458B6F3C}" presName="rootText" presStyleLbl="node1" presStyleIdx="2" presStyleCnt="4"/>
      <dgm:spPr/>
      <dgm:t>
        <a:bodyPr/>
        <a:lstStyle/>
        <a:p>
          <a:endParaRPr lang="en-US"/>
        </a:p>
      </dgm:t>
    </dgm:pt>
    <dgm:pt modelId="{FA397462-DD5F-9648-A607-80B554668E12}" type="pres">
      <dgm:prSet presAssocID="{963860DD-75C3-A04D-A927-C241458B6F3C}" presName="rootConnector" presStyleLbl="node1" presStyleIdx="2" presStyleCnt="4"/>
      <dgm:spPr/>
      <dgm:t>
        <a:bodyPr/>
        <a:lstStyle/>
        <a:p>
          <a:endParaRPr lang="en-US"/>
        </a:p>
      </dgm:t>
    </dgm:pt>
    <dgm:pt modelId="{3AAD87C0-32D5-1B44-9119-72530E815689}" type="pres">
      <dgm:prSet presAssocID="{963860DD-75C3-A04D-A927-C241458B6F3C}" presName="childShape" presStyleCnt="0"/>
      <dgm:spPr/>
    </dgm:pt>
    <dgm:pt modelId="{B2B91806-4CB7-A746-ACF8-87694383FD77}" type="pres">
      <dgm:prSet presAssocID="{2186ADFF-6C6E-D442-9103-38B3AC49A987}" presName="Name13" presStyleLbl="parChTrans1D2" presStyleIdx="10" presStyleCnt="12"/>
      <dgm:spPr/>
      <dgm:t>
        <a:bodyPr/>
        <a:lstStyle/>
        <a:p>
          <a:endParaRPr lang="en-US"/>
        </a:p>
      </dgm:t>
    </dgm:pt>
    <dgm:pt modelId="{A6F559FE-7689-D241-90F8-CE83E7A71DC9}" type="pres">
      <dgm:prSet presAssocID="{5A2245D1-57D6-334B-8725-052B522D46A0}" presName="childText" presStyleLbl="bgAcc1" presStyleIdx="10" presStyleCnt="12" custScaleY="28307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9F13DD3-D987-DE46-A6CB-0BB184817DB9}" type="pres">
      <dgm:prSet presAssocID="{13E8538C-82C2-AA4F-83F1-1F0F937CC84B}" presName="root" presStyleCnt="0"/>
      <dgm:spPr/>
    </dgm:pt>
    <dgm:pt modelId="{CF582829-B1B6-A741-993F-34C61DAA2578}" type="pres">
      <dgm:prSet presAssocID="{13E8538C-82C2-AA4F-83F1-1F0F937CC84B}" presName="rootComposite" presStyleCnt="0"/>
      <dgm:spPr/>
    </dgm:pt>
    <dgm:pt modelId="{DD58C3A6-B726-9540-84D9-6F2B86F9B425}" type="pres">
      <dgm:prSet presAssocID="{13E8538C-82C2-AA4F-83F1-1F0F937CC84B}" presName="rootText" presStyleLbl="node1" presStyleIdx="3" presStyleCnt="4"/>
      <dgm:spPr/>
      <dgm:t>
        <a:bodyPr/>
        <a:lstStyle/>
        <a:p>
          <a:endParaRPr lang="en-US"/>
        </a:p>
      </dgm:t>
    </dgm:pt>
    <dgm:pt modelId="{F65E9D8E-060F-4949-AB84-E63591C24CFD}" type="pres">
      <dgm:prSet presAssocID="{13E8538C-82C2-AA4F-83F1-1F0F937CC84B}" presName="rootConnector" presStyleLbl="node1" presStyleIdx="3" presStyleCnt="4"/>
      <dgm:spPr/>
      <dgm:t>
        <a:bodyPr/>
        <a:lstStyle/>
        <a:p>
          <a:endParaRPr lang="en-US"/>
        </a:p>
      </dgm:t>
    </dgm:pt>
    <dgm:pt modelId="{CF44395E-544F-ED48-8BFD-6C5E75DAB75D}" type="pres">
      <dgm:prSet presAssocID="{13E8538C-82C2-AA4F-83F1-1F0F937CC84B}" presName="childShape" presStyleCnt="0"/>
      <dgm:spPr/>
    </dgm:pt>
    <dgm:pt modelId="{1764CA4D-9235-704F-926A-D0F9F581EF23}" type="pres">
      <dgm:prSet presAssocID="{D8ECBF77-D655-C346-9222-8D9676561FF4}" presName="Name13" presStyleLbl="parChTrans1D2" presStyleIdx="11" presStyleCnt="12"/>
      <dgm:spPr/>
      <dgm:t>
        <a:bodyPr/>
        <a:lstStyle/>
        <a:p>
          <a:endParaRPr lang="en-US"/>
        </a:p>
      </dgm:t>
    </dgm:pt>
    <dgm:pt modelId="{643E91C6-4642-A14C-8D93-8F668859FEFB}" type="pres">
      <dgm:prSet presAssocID="{F92EFC32-CB7B-BC4D-823B-E21A5D7BECC6}" presName="childText" presStyleLbl="bgAcc1" presStyleIdx="11" presStyleCnt="12" custScaleY="554997" custLinFactNeighborX="-3464" custLinFactNeighborY="9239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406B27A3-8B91-8341-9F6E-2B639C47916A}" type="presOf" srcId="{CA7D790B-19FC-5149-9599-243F05F23FC6}" destId="{F514985B-8F89-3E40-A9D7-AAE0741148EB}" srcOrd="0" destOrd="0" presId="urn:microsoft.com/office/officeart/2005/8/layout/hierarchy3"/>
    <dgm:cxn modelId="{3107DFF0-0CB7-1347-AE69-9E4E555F671C}" type="presOf" srcId="{033AC75A-C0AB-1E4A-BF1F-D1116EA64355}" destId="{20585FAD-6B7F-0842-B28E-27488CB988F9}" srcOrd="0" destOrd="0" presId="urn:microsoft.com/office/officeart/2005/8/layout/hierarchy3"/>
    <dgm:cxn modelId="{4DBDCD7A-3405-094F-B572-1DBA92C7D5E8}" srcId="{33486641-08D6-BB44-86D7-DD7EF297090A}" destId="{D8E06292-CAA4-E04A-97EA-9BE72EC3D7ED}" srcOrd="1" destOrd="0" parTransId="{E18B0DF2-8BE4-674C-A03C-3A3C31B9BE9F}" sibTransId="{1F939C9F-4624-D147-8C1D-624713BF7DB7}"/>
    <dgm:cxn modelId="{D14CBBE8-8D68-E84E-9BF6-5D6C7D74CDA9}" type="presOf" srcId="{D8E06292-CAA4-E04A-97EA-9BE72EC3D7ED}" destId="{4AF55A52-1DB8-8C40-B49B-DF4BC4452D80}" srcOrd="1" destOrd="0" presId="urn:microsoft.com/office/officeart/2005/8/layout/hierarchy3"/>
    <dgm:cxn modelId="{EE9BF278-6066-8343-92D6-EFF2897FD2C4}" type="presOf" srcId="{D8ECBF77-D655-C346-9222-8D9676561FF4}" destId="{1764CA4D-9235-704F-926A-D0F9F581EF23}" srcOrd="0" destOrd="0" presId="urn:microsoft.com/office/officeart/2005/8/layout/hierarchy3"/>
    <dgm:cxn modelId="{9F7F85F5-D658-E049-9825-EAB2590A0BD8}" type="presOf" srcId="{9DCCF5E4-AFF2-484B-9474-3158221EE852}" destId="{BBD6F990-7533-094E-BD4F-577B4751F3B0}" srcOrd="0" destOrd="0" presId="urn:microsoft.com/office/officeart/2005/8/layout/hierarchy3"/>
    <dgm:cxn modelId="{6E924DBE-3690-0345-BE08-059AABE4B43E}" type="presOf" srcId="{FA0C812A-09BB-D843-8229-203E5F468885}" destId="{38F3191D-4F4C-B346-9CC0-DE14BF92C87E}" srcOrd="0" destOrd="0" presId="urn:microsoft.com/office/officeart/2005/8/layout/hierarchy3"/>
    <dgm:cxn modelId="{CB7B2207-ABE5-47C4-91EC-996D6399EC6F}" srcId="{49A4CC4B-F1F8-9243-9DC8-977908927EEF}" destId="{AC3103BF-ED2F-4AD6-984F-D26B3CC198DA}" srcOrd="3" destOrd="0" parTransId="{CDBAC1A8-9875-4E34-9519-A34D6B610283}" sibTransId="{1117BA25-87BA-423B-BFA0-C78708B4AF15}"/>
    <dgm:cxn modelId="{DC468B29-FF81-244C-820E-4AD16C8124CA}" type="presOf" srcId="{49A4CC4B-F1F8-9243-9DC8-977908927EEF}" destId="{94A5071D-E87E-3F48-97FC-EEDF62B6BB25}" srcOrd="0" destOrd="0" presId="urn:microsoft.com/office/officeart/2005/8/layout/hierarchy3"/>
    <dgm:cxn modelId="{031CBBC1-B2BD-CF48-A48A-6D8832759B20}" srcId="{963860DD-75C3-A04D-A927-C241458B6F3C}" destId="{5A2245D1-57D6-334B-8725-052B522D46A0}" srcOrd="0" destOrd="0" parTransId="{2186ADFF-6C6E-D442-9103-38B3AC49A987}" sibTransId="{A6DE2CC7-EF8E-6D49-818C-C6826EABB58F}"/>
    <dgm:cxn modelId="{0C41789E-0286-4F49-B207-C85868B97F2D}" type="presOf" srcId="{33486641-08D6-BB44-86D7-DD7EF297090A}" destId="{C004C2A9-2C90-9B41-988E-F050F5BC880D}" srcOrd="0" destOrd="0" presId="urn:microsoft.com/office/officeart/2005/8/layout/hierarchy3"/>
    <dgm:cxn modelId="{941AF7C8-F506-8C4C-9E1C-D8482F67FE7E}" type="presOf" srcId="{2D17E121-C6E3-3B4E-9F39-43D133BE1348}" destId="{48BB2E1E-E7E2-C04E-AC65-448851DF6121}" srcOrd="0" destOrd="0" presId="urn:microsoft.com/office/officeart/2005/8/layout/hierarchy3"/>
    <dgm:cxn modelId="{E3D87DD0-B492-1148-9527-9CDEEAD99664}" type="presOf" srcId="{029F9BB8-423E-5E4D-B120-C84233D4E844}" destId="{CFA2FF03-5E02-2247-A6FA-5F40E097B375}" srcOrd="0" destOrd="0" presId="urn:microsoft.com/office/officeart/2005/8/layout/hierarchy3"/>
    <dgm:cxn modelId="{C22FFC7F-8F2D-0648-BCBD-C749F286F708}" srcId="{33486641-08D6-BB44-86D7-DD7EF297090A}" destId="{963860DD-75C3-A04D-A927-C241458B6F3C}" srcOrd="2" destOrd="0" parTransId="{6D7B02F2-E111-004B-8E5F-412C7F30176F}" sibTransId="{773F61A4-5E32-E746-B182-9F1BDAD05480}"/>
    <dgm:cxn modelId="{EE1C0397-D064-1249-BE66-A626F81767E4}" srcId="{49A4CC4B-F1F8-9243-9DC8-977908927EEF}" destId="{B24E0B99-7158-734C-B57A-397221519A5F}" srcOrd="1" destOrd="0" parTransId="{31E54F99-F707-6D4C-B272-8106A5F56A45}" sibTransId="{89489314-66F9-0548-8D25-DC763A39243C}"/>
    <dgm:cxn modelId="{B47A4A1B-3BA1-F548-99EC-12461EC8A52E}" srcId="{49A4CC4B-F1F8-9243-9DC8-977908927EEF}" destId="{0AFA9355-AD3C-3442-A7A5-5363B6663959}" srcOrd="2" destOrd="0" parTransId="{5C12194D-DBA3-7043-95AD-E5B6CB0CA537}" sibTransId="{5F803EFD-D486-EA4A-9564-51FEB532E622}"/>
    <dgm:cxn modelId="{A62DE850-FDA1-2B43-AA24-2B3437ACCC0D}" type="presOf" srcId="{963860DD-75C3-A04D-A927-C241458B6F3C}" destId="{18D50664-5D57-6B47-A4A5-3F64BC291717}" srcOrd="0" destOrd="0" presId="urn:microsoft.com/office/officeart/2005/8/layout/hierarchy3"/>
    <dgm:cxn modelId="{9F9FDC3A-FD31-4B8A-9D5E-9D7144B42008}" type="presOf" srcId="{AC3103BF-ED2F-4AD6-984F-D26B3CC198DA}" destId="{3A4250D4-BCFC-4F02-91C6-FC6809063146}" srcOrd="0" destOrd="0" presId="urn:microsoft.com/office/officeart/2005/8/layout/hierarchy3"/>
    <dgm:cxn modelId="{0D05DC74-B367-6F40-9F1B-EE19C4965CD7}" type="presOf" srcId="{AE534E73-15B3-6B4C-B71D-B94FD7888D77}" destId="{2F859DD4-E5EA-2341-917D-7C036D3F7456}" srcOrd="0" destOrd="0" presId="urn:microsoft.com/office/officeart/2005/8/layout/hierarchy3"/>
    <dgm:cxn modelId="{4AB32705-C73F-C84E-A270-66C610D67F5F}" srcId="{49A4CC4B-F1F8-9243-9DC8-977908927EEF}" destId="{13D28453-A091-6842-96AF-AAB42DA0EA5D}" srcOrd="4" destOrd="0" parTransId="{033AC75A-C0AB-1E4A-BF1F-D1116EA64355}" sibTransId="{167E7A1C-56FD-1F46-AD5E-D5E972E02EDD}"/>
    <dgm:cxn modelId="{0E08B30E-814C-EE4B-8CE8-964E0402D628}" type="presOf" srcId="{971FF5C4-01E5-C044-8273-63D872A89BE1}" destId="{C86D4C91-F832-0544-8E40-408CDB1BD0FE}" srcOrd="0" destOrd="0" presId="urn:microsoft.com/office/officeart/2005/8/layout/hierarchy3"/>
    <dgm:cxn modelId="{0E588AD2-2250-EF43-92DF-CB6E55099B07}" type="presOf" srcId="{B24E0B99-7158-734C-B57A-397221519A5F}" destId="{2F6C24A4-7B08-6D4C-A6B2-7105D71A78BF}" srcOrd="0" destOrd="0" presId="urn:microsoft.com/office/officeart/2005/8/layout/hierarchy3"/>
    <dgm:cxn modelId="{3254FC4D-4548-A649-9019-C0712D04F64A}" srcId="{13E8538C-82C2-AA4F-83F1-1F0F937CC84B}" destId="{F92EFC32-CB7B-BC4D-823B-E21A5D7BECC6}" srcOrd="0" destOrd="0" parTransId="{D8ECBF77-D655-C346-9222-8D9676561FF4}" sibTransId="{79B52032-CEDF-3F47-A6CA-7547C085E7A3}"/>
    <dgm:cxn modelId="{77C8DBD0-410E-6E4E-85F2-1F903241DF64}" type="presOf" srcId="{13E8538C-82C2-AA4F-83F1-1F0F937CC84B}" destId="{DD58C3A6-B726-9540-84D9-6F2B86F9B425}" srcOrd="0" destOrd="0" presId="urn:microsoft.com/office/officeart/2005/8/layout/hierarchy3"/>
    <dgm:cxn modelId="{1592C9BB-BC99-1A46-918F-A89C0212A06A}" type="presOf" srcId="{71D0D3AF-13D6-2441-88B4-36E15862C66F}" destId="{64A67B95-88B5-D945-A704-EC2CA0DBD6D0}" srcOrd="0" destOrd="0" presId="urn:microsoft.com/office/officeart/2005/8/layout/hierarchy3"/>
    <dgm:cxn modelId="{B81C093E-AD07-3647-8AE6-ADE57FC5838A}" type="presOf" srcId="{49A4CC4B-F1F8-9243-9DC8-977908927EEF}" destId="{64738EAF-F13B-6E40-9EF4-FB248F1A7EDA}" srcOrd="1" destOrd="0" presId="urn:microsoft.com/office/officeart/2005/8/layout/hierarchy3"/>
    <dgm:cxn modelId="{0238DBAC-FB6C-4548-B1AD-2EA0FF66B07E}" type="presOf" srcId="{5A2245D1-57D6-334B-8725-052B522D46A0}" destId="{A6F559FE-7689-D241-90F8-CE83E7A71DC9}" srcOrd="0" destOrd="0" presId="urn:microsoft.com/office/officeart/2005/8/layout/hierarchy3"/>
    <dgm:cxn modelId="{828AB0C9-4AD2-4F41-B69C-16C8590F8181}" srcId="{49A4CC4B-F1F8-9243-9DC8-977908927EEF}" destId="{2D17E121-C6E3-3B4E-9F39-43D133BE1348}" srcOrd="0" destOrd="0" parTransId="{029F9BB8-423E-5E4D-B120-C84233D4E844}" sibTransId="{EBBD09C8-0B6F-FA45-9324-E67B66118F0C}"/>
    <dgm:cxn modelId="{FCC5CF16-7E12-8A48-B211-E8A641785AC7}" srcId="{33486641-08D6-BB44-86D7-DD7EF297090A}" destId="{49A4CC4B-F1F8-9243-9DC8-977908927EEF}" srcOrd="0" destOrd="0" parTransId="{66131FCE-E483-9544-8361-A5B82051B25F}" sibTransId="{68367F81-D3CF-FE40-9450-70D9EFD8740B}"/>
    <dgm:cxn modelId="{BA035A94-DCA5-1441-816C-979AF0B9BED3}" type="presOf" srcId="{D8E06292-CAA4-E04A-97EA-9BE72EC3D7ED}" destId="{9A612BA4-470B-104D-A211-43EC4F26331B}" srcOrd="0" destOrd="0" presId="urn:microsoft.com/office/officeart/2005/8/layout/hierarchy3"/>
    <dgm:cxn modelId="{403A6870-78FE-A24E-8AD2-6ABF5B31B957}" type="presOf" srcId="{81A75B0B-6277-EA41-B4A0-D272273B6519}" destId="{6EFFD289-B693-B346-A918-E91A6BB0D027}" srcOrd="0" destOrd="0" presId="urn:microsoft.com/office/officeart/2005/8/layout/hierarchy3"/>
    <dgm:cxn modelId="{147BFBB0-AE01-6D4B-88EB-99F61D8CC122}" srcId="{D8E06292-CAA4-E04A-97EA-9BE72EC3D7ED}" destId="{81A75B0B-6277-EA41-B4A0-D272273B6519}" srcOrd="1" destOrd="0" parTransId="{AE534E73-15B3-6B4C-B71D-B94FD7888D77}" sibTransId="{E3B44061-4E24-A148-A211-BE31F700B820}"/>
    <dgm:cxn modelId="{688900D8-8926-6148-B297-7FBA718AA04E}" type="presOf" srcId="{F92EFC32-CB7B-BC4D-823B-E21A5D7BECC6}" destId="{643E91C6-4642-A14C-8D93-8F668859FEFB}" srcOrd="0" destOrd="0" presId="urn:microsoft.com/office/officeart/2005/8/layout/hierarchy3"/>
    <dgm:cxn modelId="{DCB08E58-1F9E-4E40-B5C8-7562B3B9AA5A}" srcId="{D8E06292-CAA4-E04A-97EA-9BE72EC3D7ED}" destId="{555B88C6-1EC4-B044-A582-FF943C32DE05}" srcOrd="4" destOrd="0" parTransId="{41D0A532-0EAE-CD4A-B789-CB3652F00DC2}" sibTransId="{3FF66635-E62B-4A40-8032-0B7AECB67AA1}"/>
    <dgm:cxn modelId="{18084EBF-8CEA-45B1-B9C7-8BA954D64B9D}" type="presOf" srcId="{CDBAC1A8-9875-4E34-9519-A34D6B610283}" destId="{2EC73E89-6E20-4C32-A35B-3837FE7DDDC9}" srcOrd="0" destOrd="0" presId="urn:microsoft.com/office/officeart/2005/8/layout/hierarchy3"/>
    <dgm:cxn modelId="{8F54BCB5-F404-484C-A515-4ABF92CD9CBF}" type="presOf" srcId="{963860DD-75C3-A04D-A927-C241458B6F3C}" destId="{FA397462-DD5F-9648-A607-80B554668E12}" srcOrd="1" destOrd="0" presId="urn:microsoft.com/office/officeart/2005/8/layout/hierarchy3"/>
    <dgm:cxn modelId="{D2CEF025-33D2-C847-8C1F-02CB44166358}" srcId="{33486641-08D6-BB44-86D7-DD7EF297090A}" destId="{13E8538C-82C2-AA4F-83F1-1F0F937CC84B}" srcOrd="3" destOrd="0" parTransId="{D612F36E-FB0E-4743-A91E-F05004136286}" sibTransId="{CFC66188-75BE-0346-8119-E1C9E6DBE760}"/>
    <dgm:cxn modelId="{5505FA5E-C2A9-7040-B28F-8A6F9EA06CE9}" srcId="{D8E06292-CAA4-E04A-97EA-9BE72EC3D7ED}" destId="{9DCCF5E4-AFF2-484B-9474-3158221EE852}" srcOrd="0" destOrd="0" parTransId="{971FF5C4-01E5-C044-8273-63D872A89BE1}" sibTransId="{0DAF8392-B31C-4D42-BCB4-92EF762BD21D}"/>
    <dgm:cxn modelId="{03561D98-FDAF-5648-931F-0D95C2BF877E}" type="presOf" srcId="{41D0A532-0EAE-CD4A-B789-CB3652F00DC2}" destId="{B7EF5D09-D349-7747-B40E-22C22407BDA5}" srcOrd="0" destOrd="0" presId="urn:microsoft.com/office/officeart/2005/8/layout/hierarchy3"/>
    <dgm:cxn modelId="{F5A3DF41-E9EB-C247-84E2-39506751A6DC}" type="presOf" srcId="{14E3DAFC-CE71-5147-955D-A330275854D5}" destId="{9DDB4C29-ED3F-EF44-8E3E-8512077A4EE2}" srcOrd="0" destOrd="0" presId="urn:microsoft.com/office/officeart/2005/8/layout/hierarchy3"/>
    <dgm:cxn modelId="{26C0B56A-56F9-2E4F-A0CA-CC50D858E411}" srcId="{D8E06292-CAA4-E04A-97EA-9BE72EC3D7ED}" destId="{FA0C812A-09BB-D843-8229-203E5F468885}" srcOrd="2" destOrd="0" parTransId="{CA7D790B-19FC-5149-9599-243F05F23FC6}" sibTransId="{917CBE3C-42EC-714C-8C54-99A6FA4C67BC}"/>
    <dgm:cxn modelId="{6E5975C6-574D-1E42-88AF-93BDC1B353EE}" type="presOf" srcId="{13E8538C-82C2-AA4F-83F1-1F0F937CC84B}" destId="{F65E9D8E-060F-4949-AB84-E63591C24CFD}" srcOrd="1" destOrd="0" presId="urn:microsoft.com/office/officeart/2005/8/layout/hierarchy3"/>
    <dgm:cxn modelId="{B66A3722-F472-1D49-A2BF-AE5745C17983}" type="presOf" srcId="{0AFA9355-AD3C-3442-A7A5-5363B6663959}" destId="{729C8DBA-3E59-624C-B017-6AE52DA0554A}" srcOrd="0" destOrd="0" presId="urn:microsoft.com/office/officeart/2005/8/layout/hierarchy3"/>
    <dgm:cxn modelId="{156DC008-BBF7-8B4B-BB9F-277AB9920B2E}" type="presOf" srcId="{5C12194D-DBA3-7043-95AD-E5B6CB0CA537}" destId="{B3030BE9-41EF-7B4C-833E-A4DB457C8CDA}" srcOrd="0" destOrd="0" presId="urn:microsoft.com/office/officeart/2005/8/layout/hierarchy3"/>
    <dgm:cxn modelId="{F28BCEEF-0750-944D-BE53-4177C4F02EBB}" type="presOf" srcId="{13D28453-A091-6842-96AF-AAB42DA0EA5D}" destId="{CD58BF61-E173-834C-9C3A-78CC0740BFE8}" srcOrd="0" destOrd="0" presId="urn:microsoft.com/office/officeart/2005/8/layout/hierarchy3"/>
    <dgm:cxn modelId="{60F638BE-3179-6A40-A6A2-8C5345B33425}" type="presOf" srcId="{555B88C6-1EC4-B044-A582-FF943C32DE05}" destId="{7D8DDBCB-1F4F-F841-9C74-8CDAB5C7900A}" srcOrd="0" destOrd="0" presId="urn:microsoft.com/office/officeart/2005/8/layout/hierarchy3"/>
    <dgm:cxn modelId="{10E1ABA9-EFFB-634A-8EB4-8F699A5A1962}" srcId="{D8E06292-CAA4-E04A-97EA-9BE72EC3D7ED}" destId="{14E3DAFC-CE71-5147-955D-A330275854D5}" srcOrd="3" destOrd="0" parTransId="{71D0D3AF-13D6-2441-88B4-36E15862C66F}" sibTransId="{9F5F98DB-DDDF-D945-BA26-1EF1CC09E196}"/>
    <dgm:cxn modelId="{2C1833E1-3D1A-0B43-A8CE-74B1ADFF03F3}" type="presOf" srcId="{2186ADFF-6C6E-D442-9103-38B3AC49A987}" destId="{B2B91806-4CB7-A746-ACF8-87694383FD77}" srcOrd="0" destOrd="0" presId="urn:microsoft.com/office/officeart/2005/8/layout/hierarchy3"/>
    <dgm:cxn modelId="{F71150BB-C5CC-2F42-8B7E-ED05DE891BFB}" type="presOf" srcId="{31E54F99-F707-6D4C-B272-8106A5F56A45}" destId="{409D2DF8-AB56-7A4A-9BDA-7C8A7AFD3BC4}" srcOrd="0" destOrd="0" presId="urn:microsoft.com/office/officeart/2005/8/layout/hierarchy3"/>
    <dgm:cxn modelId="{1ED12F98-2DD4-DE4C-960A-ACC4DE538521}" type="presParOf" srcId="{C004C2A9-2C90-9B41-988E-F050F5BC880D}" destId="{EBFFA279-618E-A649-A6A7-F7172E4C5679}" srcOrd="0" destOrd="0" presId="urn:microsoft.com/office/officeart/2005/8/layout/hierarchy3"/>
    <dgm:cxn modelId="{7C7CA900-17C8-9D4B-A7A7-EC1258E27A11}" type="presParOf" srcId="{EBFFA279-618E-A649-A6A7-F7172E4C5679}" destId="{729ED895-7ABF-0E4F-A5CA-6387061ED964}" srcOrd="0" destOrd="0" presId="urn:microsoft.com/office/officeart/2005/8/layout/hierarchy3"/>
    <dgm:cxn modelId="{8C2C44FA-EBF0-454D-9AE7-601908F18B6A}" type="presParOf" srcId="{729ED895-7ABF-0E4F-A5CA-6387061ED964}" destId="{94A5071D-E87E-3F48-97FC-EEDF62B6BB25}" srcOrd="0" destOrd="0" presId="urn:microsoft.com/office/officeart/2005/8/layout/hierarchy3"/>
    <dgm:cxn modelId="{3AE599CD-71D1-EF4E-B731-822A9F728B47}" type="presParOf" srcId="{729ED895-7ABF-0E4F-A5CA-6387061ED964}" destId="{64738EAF-F13B-6E40-9EF4-FB248F1A7EDA}" srcOrd="1" destOrd="0" presId="urn:microsoft.com/office/officeart/2005/8/layout/hierarchy3"/>
    <dgm:cxn modelId="{CD2798BD-E205-6E4E-9708-3EE6A338308D}" type="presParOf" srcId="{EBFFA279-618E-A649-A6A7-F7172E4C5679}" destId="{05414C9E-5216-D64D-8920-61BC7FBBDF5C}" srcOrd="1" destOrd="0" presId="urn:microsoft.com/office/officeart/2005/8/layout/hierarchy3"/>
    <dgm:cxn modelId="{38D74385-B17F-5547-A0ED-F49F55FC35FB}" type="presParOf" srcId="{05414C9E-5216-D64D-8920-61BC7FBBDF5C}" destId="{CFA2FF03-5E02-2247-A6FA-5F40E097B375}" srcOrd="0" destOrd="0" presId="urn:microsoft.com/office/officeart/2005/8/layout/hierarchy3"/>
    <dgm:cxn modelId="{B6B7638E-777A-8A4C-93A2-2E1A5A1C70BC}" type="presParOf" srcId="{05414C9E-5216-D64D-8920-61BC7FBBDF5C}" destId="{48BB2E1E-E7E2-C04E-AC65-448851DF6121}" srcOrd="1" destOrd="0" presId="urn:microsoft.com/office/officeart/2005/8/layout/hierarchy3"/>
    <dgm:cxn modelId="{BE50FD3F-61EC-1645-A7BD-10EFACD53F7C}" type="presParOf" srcId="{05414C9E-5216-D64D-8920-61BC7FBBDF5C}" destId="{409D2DF8-AB56-7A4A-9BDA-7C8A7AFD3BC4}" srcOrd="2" destOrd="0" presId="urn:microsoft.com/office/officeart/2005/8/layout/hierarchy3"/>
    <dgm:cxn modelId="{FC73012F-30E7-754E-B188-C4E88A44FB6A}" type="presParOf" srcId="{05414C9E-5216-D64D-8920-61BC7FBBDF5C}" destId="{2F6C24A4-7B08-6D4C-A6B2-7105D71A78BF}" srcOrd="3" destOrd="0" presId="urn:microsoft.com/office/officeart/2005/8/layout/hierarchy3"/>
    <dgm:cxn modelId="{F6CD06F0-62EA-5C48-94EA-4F380F8C94B3}" type="presParOf" srcId="{05414C9E-5216-D64D-8920-61BC7FBBDF5C}" destId="{B3030BE9-41EF-7B4C-833E-A4DB457C8CDA}" srcOrd="4" destOrd="0" presId="urn:microsoft.com/office/officeart/2005/8/layout/hierarchy3"/>
    <dgm:cxn modelId="{88A658A5-C798-2C4B-A426-D7FB86DBA6A4}" type="presParOf" srcId="{05414C9E-5216-D64D-8920-61BC7FBBDF5C}" destId="{729C8DBA-3E59-624C-B017-6AE52DA0554A}" srcOrd="5" destOrd="0" presId="urn:microsoft.com/office/officeart/2005/8/layout/hierarchy3"/>
    <dgm:cxn modelId="{E4B4E398-BD5A-4437-8EBB-FDEA84BD3843}" type="presParOf" srcId="{05414C9E-5216-D64D-8920-61BC7FBBDF5C}" destId="{2EC73E89-6E20-4C32-A35B-3837FE7DDDC9}" srcOrd="6" destOrd="0" presId="urn:microsoft.com/office/officeart/2005/8/layout/hierarchy3"/>
    <dgm:cxn modelId="{37F27051-9890-4B70-A0DA-DD7341C87601}" type="presParOf" srcId="{05414C9E-5216-D64D-8920-61BC7FBBDF5C}" destId="{3A4250D4-BCFC-4F02-91C6-FC6809063146}" srcOrd="7" destOrd="0" presId="urn:microsoft.com/office/officeart/2005/8/layout/hierarchy3"/>
    <dgm:cxn modelId="{8D102CDE-6A0C-554A-B245-383D6C3EC7E0}" type="presParOf" srcId="{05414C9E-5216-D64D-8920-61BC7FBBDF5C}" destId="{20585FAD-6B7F-0842-B28E-27488CB988F9}" srcOrd="8" destOrd="0" presId="urn:microsoft.com/office/officeart/2005/8/layout/hierarchy3"/>
    <dgm:cxn modelId="{AECAC0FF-4F66-024C-8727-B75A0B055ABF}" type="presParOf" srcId="{05414C9E-5216-D64D-8920-61BC7FBBDF5C}" destId="{CD58BF61-E173-834C-9C3A-78CC0740BFE8}" srcOrd="9" destOrd="0" presId="urn:microsoft.com/office/officeart/2005/8/layout/hierarchy3"/>
    <dgm:cxn modelId="{631107B1-ACAE-F041-BCE5-120F38E5112D}" type="presParOf" srcId="{C004C2A9-2C90-9B41-988E-F050F5BC880D}" destId="{631565AA-D496-2247-9D82-6C5B9AB61014}" srcOrd="1" destOrd="0" presId="urn:microsoft.com/office/officeart/2005/8/layout/hierarchy3"/>
    <dgm:cxn modelId="{EF3A35DB-1F4B-6C40-A6EC-7DC2AB9BF53C}" type="presParOf" srcId="{631565AA-D496-2247-9D82-6C5B9AB61014}" destId="{DF03C3C1-2FD8-374A-8533-04456DCA8D93}" srcOrd="0" destOrd="0" presId="urn:microsoft.com/office/officeart/2005/8/layout/hierarchy3"/>
    <dgm:cxn modelId="{A2785F96-CB36-4141-9806-80F12D4294C4}" type="presParOf" srcId="{DF03C3C1-2FD8-374A-8533-04456DCA8D93}" destId="{9A612BA4-470B-104D-A211-43EC4F26331B}" srcOrd="0" destOrd="0" presId="urn:microsoft.com/office/officeart/2005/8/layout/hierarchy3"/>
    <dgm:cxn modelId="{C1EE9AA3-66C1-5D44-9452-56DCF734C3D3}" type="presParOf" srcId="{DF03C3C1-2FD8-374A-8533-04456DCA8D93}" destId="{4AF55A52-1DB8-8C40-B49B-DF4BC4452D80}" srcOrd="1" destOrd="0" presId="urn:microsoft.com/office/officeart/2005/8/layout/hierarchy3"/>
    <dgm:cxn modelId="{35B08842-5762-F54A-BE39-603787DCD37E}" type="presParOf" srcId="{631565AA-D496-2247-9D82-6C5B9AB61014}" destId="{6A2F78E1-C6B0-5241-845A-26ADF1867596}" srcOrd="1" destOrd="0" presId="urn:microsoft.com/office/officeart/2005/8/layout/hierarchy3"/>
    <dgm:cxn modelId="{43214710-3BB3-9042-861E-3ECEBE04BB53}" type="presParOf" srcId="{6A2F78E1-C6B0-5241-845A-26ADF1867596}" destId="{C86D4C91-F832-0544-8E40-408CDB1BD0FE}" srcOrd="0" destOrd="0" presId="urn:microsoft.com/office/officeart/2005/8/layout/hierarchy3"/>
    <dgm:cxn modelId="{9E591D31-9697-C249-8D67-95C148D25144}" type="presParOf" srcId="{6A2F78E1-C6B0-5241-845A-26ADF1867596}" destId="{BBD6F990-7533-094E-BD4F-577B4751F3B0}" srcOrd="1" destOrd="0" presId="urn:microsoft.com/office/officeart/2005/8/layout/hierarchy3"/>
    <dgm:cxn modelId="{C903DFB1-1040-0F46-9EF5-E07AD9E9FD62}" type="presParOf" srcId="{6A2F78E1-C6B0-5241-845A-26ADF1867596}" destId="{2F859DD4-E5EA-2341-917D-7C036D3F7456}" srcOrd="2" destOrd="0" presId="urn:microsoft.com/office/officeart/2005/8/layout/hierarchy3"/>
    <dgm:cxn modelId="{47ED1256-91D0-3B4F-A6E5-1B0B1A70026D}" type="presParOf" srcId="{6A2F78E1-C6B0-5241-845A-26ADF1867596}" destId="{6EFFD289-B693-B346-A918-E91A6BB0D027}" srcOrd="3" destOrd="0" presId="urn:microsoft.com/office/officeart/2005/8/layout/hierarchy3"/>
    <dgm:cxn modelId="{519F4523-6846-6247-A2D3-FE7FAD2A0012}" type="presParOf" srcId="{6A2F78E1-C6B0-5241-845A-26ADF1867596}" destId="{F514985B-8F89-3E40-A9D7-AAE0741148EB}" srcOrd="4" destOrd="0" presId="urn:microsoft.com/office/officeart/2005/8/layout/hierarchy3"/>
    <dgm:cxn modelId="{3033A473-573D-6049-A73A-7F767A082CDE}" type="presParOf" srcId="{6A2F78E1-C6B0-5241-845A-26ADF1867596}" destId="{38F3191D-4F4C-B346-9CC0-DE14BF92C87E}" srcOrd="5" destOrd="0" presId="urn:microsoft.com/office/officeart/2005/8/layout/hierarchy3"/>
    <dgm:cxn modelId="{70293844-94A5-6B4C-893F-6CB1E90FB270}" type="presParOf" srcId="{6A2F78E1-C6B0-5241-845A-26ADF1867596}" destId="{64A67B95-88B5-D945-A704-EC2CA0DBD6D0}" srcOrd="6" destOrd="0" presId="urn:microsoft.com/office/officeart/2005/8/layout/hierarchy3"/>
    <dgm:cxn modelId="{844204E5-DF5F-D146-8BF2-5580A494EFAA}" type="presParOf" srcId="{6A2F78E1-C6B0-5241-845A-26ADF1867596}" destId="{9DDB4C29-ED3F-EF44-8E3E-8512077A4EE2}" srcOrd="7" destOrd="0" presId="urn:microsoft.com/office/officeart/2005/8/layout/hierarchy3"/>
    <dgm:cxn modelId="{7FD47BCD-9891-514B-8B0E-B72998A980A6}" type="presParOf" srcId="{6A2F78E1-C6B0-5241-845A-26ADF1867596}" destId="{B7EF5D09-D349-7747-B40E-22C22407BDA5}" srcOrd="8" destOrd="0" presId="urn:microsoft.com/office/officeart/2005/8/layout/hierarchy3"/>
    <dgm:cxn modelId="{9B445271-9651-2348-A2B4-39BEC33F4F5A}" type="presParOf" srcId="{6A2F78E1-C6B0-5241-845A-26ADF1867596}" destId="{7D8DDBCB-1F4F-F841-9C74-8CDAB5C7900A}" srcOrd="9" destOrd="0" presId="urn:microsoft.com/office/officeart/2005/8/layout/hierarchy3"/>
    <dgm:cxn modelId="{38EF43B8-A383-CB4C-B5EB-6DEE5FCED49E}" type="presParOf" srcId="{C004C2A9-2C90-9B41-988E-F050F5BC880D}" destId="{2CAD5CFE-7D02-1747-94C3-56C47AEB86A7}" srcOrd="2" destOrd="0" presId="urn:microsoft.com/office/officeart/2005/8/layout/hierarchy3"/>
    <dgm:cxn modelId="{B1E387EF-8B47-724E-9932-DE2F9FFA853F}" type="presParOf" srcId="{2CAD5CFE-7D02-1747-94C3-56C47AEB86A7}" destId="{4AFF09CE-F42A-2647-AFFE-42B5C37ECE3D}" srcOrd="0" destOrd="0" presId="urn:microsoft.com/office/officeart/2005/8/layout/hierarchy3"/>
    <dgm:cxn modelId="{EE194B7C-3618-A849-AD2F-2779F1D24F8A}" type="presParOf" srcId="{4AFF09CE-F42A-2647-AFFE-42B5C37ECE3D}" destId="{18D50664-5D57-6B47-A4A5-3F64BC291717}" srcOrd="0" destOrd="0" presId="urn:microsoft.com/office/officeart/2005/8/layout/hierarchy3"/>
    <dgm:cxn modelId="{23A28ED6-1950-CC4E-97A5-0610A4C88D76}" type="presParOf" srcId="{4AFF09CE-F42A-2647-AFFE-42B5C37ECE3D}" destId="{FA397462-DD5F-9648-A607-80B554668E12}" srcOrd="1" destOrd="0" presId="urn:microsoft.com/office/officeart/2005/8/layout/hierarchy3"/>
    <dgm:cxn modelId="{3A079FBE-B2AF-774C-BEFB-0A314DE122CC}" type="presParOf" srcId="{2CAD5CFE-7D02-1747-94C3-56C47AEB86A7}" destId="{3AAD87C0-32D5-1B44-9119-72530E815689}" srcOrd="1" destOrd="0" presId="urn:microsoft.com/office/officeart/2005/8/layout/hierarchy3"/>
    <dgm:cxn modelId="{52C95558-BBE6-2D44-ABAD-82833B40AACE}" type="presParOf" srcId="{3AAD87C0-32D5-1B44-9119-72530E815689}" destId="{B2B91806-4CB7-A746-ACF8-87694383FD77}" srcOrd="0" destOrd="0" presId="urn:microsoft.com/office/officeart/2005/8/layout/hierarchy3"/>
    <dgm:cxn modelId="{9EB6D259-93A2-2C45-B7B5-CF2B1542BF2E}" type="presParOf" srcId="{3AAD87C0-32D5-1B44-9119-72530E815689}" destId="{A6F559FE-7689-D241-90F8-CE83E7A71DC9}" srcOrd="1" destOrd="0" presId="urn:microsoft.com/office/officeart/2005/8/layout/hierarchy3"/>
    <dgm:cxn modelId="{8CB86EE8-7CD2-B044-8E7A-C7C89EB68C6E}" type="presParOf" srcId="{C004C2A9-2C90-9B41-988E-F050F5BC880D}" destId="{59F13DD3-D987-DE46-A6CB-0BB184817DB9}" srcOrd="3" destOrd="0" presId="urn:microsoft.com/office/officeart/2005/8/layout/hierarchy3"/>
    <dgm:cxn modelId="{6ADCDF2C-70FC-5B4D-ACA5-4D0C02B50A01}" type="presParOf" srcId="{59F13DD3-D987-DE46-A6CB-0BB184817DB9}" destId="{CF582829-B1B6-A741-993F-34C61DAA2578}" srcOrd="0" destOrd="0" presId="urn:microsoft.com/office/officeart/2005/8/layout/hierarchy3"/>
    <dgm:cxn modelId="{A2237D91-3BFC-5447-ADBE-E83E1B00BB23}" type="presParOf" srcId="{CF582829-B1B6-A741-993F-34C61DAA2578}" destId="{DD58C3A6-B726-9540-84D9-6F2B86F9B425}" srcOrd="0" destOrd="0" presId="urn:microsoft.com/office/officeart/2005/8/layout/hierarchy3"/>
    <dgm:cxn modelId="{C74EA922-2217-FA46-A8FE-9D242957F360}" type="presParOf" srcId="{CF582829-B1B6-A741-993F-34C61DAA2578}" destId="{F65E9D8E-060F-4949-AB84-E63591C24CFD}" srcOrd="1" destOrd="0" presId="urn:microsoft.com/office/officeart/2005/8/layout/hierarchy3"/>
    <dgm:cxn modelId="{072B6C9E-DA1A-6846-9E9E-63472FEA6231}" type="presParOf" srcId="{59F13DD3-D987-DE46-A6CB-0BB184817DB9}" destId="{CF44395E-544F-ED48-8BFD-6C5E75DAB75D}" srcOrd="1" destOrd="0" presId="urn:microsoft.com/office/officeart/2005/8/layout/hierarchy3"/>
    <dgm:cxn modelId="{F97472B8-12A3-0642-8A25-9900D7C7AB18}" type="presParOf" srcId="{CF44395E-544F-ED48-8BFD-6C5E75DAB75D}" destId="{1764CA4D-9235-704F-926A-D0F9F581EF23}" srcOrd="0" destOrd="0" presId="urn:microsoft.com/office/officeart/2005/8/layout/hierarchy3"/>
    <dgm:cxn modelId="{E3557002-A7E3-BB46-899E-A03A80291DCA}" type="presParOf" srcId="{CF44395E-544F-ED48-8BFD-6C5E75DAB75D}" destId="{643E91C6-4642-A14C-8D93-8F668859FEFB}" srcOrd="1" destOrd="0" presId="urn:microsoft.com/office/officeart/2005/8/layout/hierarchy3"/>
  </dgm:cxnLst>
  <dgm:bg/>
  <dgm:whole>
    <a:ln>
      <a:noFill/>
    </a:ln>
  </dgm:whole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4A5071D-E87E-3F48-97FC-EEDF62B6BB25}">
      <dsp:nvSpPr>
        <dsp:cNvPr id="0" name=""/>
        <dsp:cNvSpPr/>
      </dsp:nvSpPr>
      <dsp:spPr>
        <a:xfrm>
          <a:off x="873462" y="969"/>
          <a:ext cx="2072694" cy="552740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1. Identify EMMA intervention activities</a:t>
          </a:r>
          <a:endParaRPr lang="en-US" sz="1400" kern="1200" dirty="0">
            <a:solidFill>
              <a:schemeClr val="tx1"/>
            </a:solidFill>
          </a:endParaRPr>
        </a:p>
      </dsp:txBody>
      <dsp:txXfrm>
        <a:off x="889651" y="17158"/>
        <a:ext cx="2040316" cy="520362"/>
      </dsp:txXfrm>
    </dsp:sp>
    <dsp:sp modelId="{CFA2FF03-5E02-2247-A6FA-5F40E097B375}">
      <dsp:nvSpPr>
        <dsp:cNvPr id="0" name=""/>
        <dsp:cNvSpPr/>
      </dsp:nvSpPr>
      <dsp:spPr>
        <a:xfrm>
          <a:off x="1080731" y="553709"/>
          <a:ext cx="207269" cy="5154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15469"/>
              </a:lnTo>
              <a:lnTo>
                <a:pt x="207269" y="515469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8BB2E1E-E7E2-C04E-AC65-448851DF6121}">
      <dsp:nvSpPr>
        <dsp:cNvPr id="0" name=""/>
        <dsp:cNvSpPr/>
      </dsp:nvSpPr>
      <dsp:spPr>
        <a:xfrm>
          <a:off x="1288001" y="725533"/>
          <a:ext cx="1794074" cy="68729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a. Train Mother Mentors (MMs) and Supervisors (all sites)</a:t>
          </a:r>
          <a:endParaRPr lang="en-US" sz="1000" kern="1200" dirty="0"/>
        </a:p>
      </dsp:txBody>
      <dsp:txXfrm>
        <a:off x="1308131" y="745663"/>
        <a:ext cx="1753814" cy="647032"/>
      </dsp:txXfrm>
    </dsp:sp>
    <dsp:sp modelId="{409D2DF8-AB56-7A4A-9BDA-7C8A7AFD3BC4}">
      <dsp:nvSpPr>
        <dsp:cNvPr id="0" name=""/>
        <dsp:cNvSpPr/>
      </dsp:nvSpPr>
      <dsp:spPr>
        <a:xfrm>
          <a:off x="1080731" y="553709"/>
          <a:ext cx="207269" cy="13745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374584"/>
              </a:lnTo>
              <a:lnTo>
                <a:pt x="207269" y="1374584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F6C24A4-7B08-6D4C-A6B2-7105D71A78BF}">
      <dsp:nvSpPr>
        <dsp:cNvPr id="0" name=""/>
        <dsp:cNvSpPr/>
      </dsp:nvSpPr>
      <dsp:spPr>
        <a:xfrm>
          <a:off x="1288001" y="1584648"/>
          <a:ext cx="1921075" cy="68729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b. Organize space for exit visit with mother (only EMMA sites)</a:t>
          </a:r>
          <a:endParaRPr lang="en-US" sz="1000" kern="1200" dirty="0"/>
        </a:p>
      </dsp:txBody>
      <dsp:txXfrm>
        <a:off x="1308131" y="1604778"/>
        <a:ext cx="1880815" cy="647032"/>
      </dsp:txXfrm>
    </dsp:sp>
    <dsp:sp modelId="{B3030BE9-41EF-7B4C-833E-A4DB457C8CDA}">
      <dsp:nvSpPr>
        <dsp:cNvPr id="0" name=""/>
        <dsp:cNvSpPr/>
      </dsp:nvSpPr>
      <dsp:spPr>
        <a:xfrm>
          <a:off x="1080731" y="553709"/>
          <a:ext cx="207269" cy="244525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445251"/>
              </a:lnTo>
              <a:lnTo>
                <a:pt x="207269" y="2445251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29C8DBA-3E59-624C-B017-6AE52DA0554A}">
      <dsp:nvSpPr>
        <dsp:cNvPr id="0" name=""/>
        <dsp:cNvSpPr/>
      </dsp:nvSpPr>
      <dsp:spPr>
        <a:xfrm>
          <a:off x="1288001" y="2443763"/>
          <a:ext cx="1971879" cy="1110396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c. Acquire any needed technology for MM (all sites)</a:t>
          </a:r>
          <a:endParaRPr lang="en-US" sz="1000" kern="1200" dirty="0"/>
        </a:p>
      </dsp:txBody>
      <dsp:txXfrm>
        <a:off x="1320523" y="2476285"/>
        <a:ext cx="1906835" cy="1045352"/>
      </dsp:txXfrm>
    </dsp:sp>
    <dsp:sp modelId="{2EC73E89-6E20-4C32-A35B-3837FE7DDDC9}">
      <dsp:nvSpPr>
        <dsp:cNvPr id="0" name=""/>
        <dsp:cNvSpPr/>
      </dsp:nvSpPr>
      <dsp:spPr>
        <a:xfrm>
          <a:off x="1080731" y="553709"/>
          <a:ext cx="207269" cy="351591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515918"/>
              </a:lnTo>
              <a:lnTo>
                <a:pt x="207269" y="3515918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A4250D4-BCFC-4F02-91C6-FC6809063146}">
      <dsp:nvSpPr>
        <dsp:cNvPr id="0" name=""/>
        <dsp:cNvSpPr/>
      </dsp:nvSpPr>
      <dsp:spPr>
        <a:xfrm>
          <a:off x="1288001" y="3725982"/>
          <a:ext cx="1782088" cy="68729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d. On-going supplies for MMs (all sites)</a:t>
          </a:r>
          <a:endParaRPr lang="en-US" sz="1000" kern="1200" dirty="0"/>
        </a:p>
      </dsp:txBody>
      <dsp:txXfrm>
        <a:off x="1308131" y="3746112"/>
        <a:ext cx="1741828" cy="647032"/>
      </dsp:txXfrm>
    </dsp:sp>
    <dsp:sp modelId="{20585FAD-6B7F-0842-B28E-27488CB988F9}">
      <dsp:nvSpPr>
        <dsp:cNvPr id="0" name=""/>
        <dsp:cNvSpPr/>
      </dsp:nvSpPr>
      <dsp:spPr>
        <a:xfrm>
          <a:off x="1080731" y="553709"/>
          <a:ext cx="207269" cy="437503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4375033"/>
              </a:lnTo>
              <a:lnTo>
                <a:pt x="207269" y="4375033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D58BF61-E173-834C-9C3A-78CC0740BFE8}">
      <dsp:nvSpPr>
        <dsp:cNvPr id="0" name=""/>
        <dsp:cNvSpPr/>
      </dsp:nvSpPr>
      <dsp:spPr>
        <a:xfrm>
          <a:off x="1288001" y="4585097"/>
          <a:ext cx="2010686" cy="68729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e. MMs and Supervisors provide routine service activities (all sites)</a:t>
          </a:r>
          <a:endParaRPr lang="en-US" sz="1000" kern="1200" dirty="0"/>
        </a:p>
      </dsp:txBody>
      <dsp:txXfrm>
        <a:off x="1308131" y="4605227"/>
        <a:ext cx="1970426" cy="647032"/>
      </dsp:txXfrm>
    </dsp:sp>
    <dsp:sp modelId="{9A612BA4-470B-104D-A211-43EC4F26331B}">
      <dsp:nvSpPr>
        <dsp:cNvPr id="0" name=""/>
        <dsp:cNvSpPr/>
      </dsp:nvSpPr>
      <dsp:spPr>
        <a:xfrm>
          <a:off x="3367417" y="969"/>
          <a:ext cx="1374584" cy="687292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2. Estimate costs for each activity</a:t>
          </a:r>
          <a:endParaRPr lang="en-US" sz="1400" kern="1200" dirty="0">
            <a:solidFill>
              <a:schemeClr val="tx1"/>
            </a:solidFill>
          </a:endParaRPr>
        </a:p>
      </dsp:txBody>
      <dsp:txXfrm>
        <a:off x="3387547" y="21099"/>
        <a:ext cx="1334324" cy="647032"/>
      </dsp:txXfrm>
    </dsp:sp>
    <dsp:sp modelId="{C86D4C91-F832-0544-8E40-408CDB1BD0FE}">
      <dsp:nvSpPr>
        <dsp:cNvPr id="0" name=""/>
        <dsp:cNvSpPr/>
      </dsp:nvSpPr>
      <dsp:spPr>
        <a:xfrm>
          <a:off x="3504875" y="688261"/>
          <a:ext cx="137458" cy="5154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15469"/>
              </a:lnTo>
              <a:lnTo>
                <a:pt x="137458" y="515469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BD6F990-7533-094E-BD4F-577B4751F3B0}">
      <dsp:nvSpPr>
        <dsp:cNvPr id="0" name=""/>
        <dsp:cNvSpPr/>
      </dsp:nvSpPr>
      <dsp:spPr>
        <a:xfrm>
          <a:off x="3642334" y="860084"/>
          <a:ext cx="1099667" cy="68729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a. Upfront cost for trainings (training expenditures, labor for trainers, etc.) </a:t>
          </a:r>
          <a:endParaRPr lang="en-US" sz="1000" kern="1200" dirty="0"/>
        </a:p>
      </dsp:txBody>
      <dsp:txXfrm>
        <a:off x="3662464" y="880214"/>
        <a:ext cx="1059407" cy="647032"/>
      </dsp:txXfrm>
    </dsp:sp>
    <dsp:sp modelId="{2F859DD4-E5EA-2341-917D-7C036D3F7456}">
      <dsp:nvSpPr>
        <dsp:cNvPr id="0" name=""/>
        <dsp:cNvSpPr/>
      </dsp:nvSpPr>
      <dsp:spPr>
        <a:xfrm>
          <a:off x="3504875" y="688261"/>
          <a:ext cx="137458" cy="156045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560452"/>
              </a:lnTo>
              <a:lnTo>
                <a:pt x="137458" y="1560452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EFFD289-B693-B346-A918-E91A6BB0D027}">
      <dsp:nvSpPr>
        <dsp:cNvPr id="0" name=""/>
        <dsp:cNvSpPr/>
      </dsp:nvSpPr>
      <dsp:spPr>
        <a:xfrm>
          <a:off x="3642334" y="1719199"/>
          <a:ext cx="1099667" cy="105902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b. Any up front cost for organizing space (renovations). Information from program records. </a:t>
          </a:r>
          <a:endParaRPr lang="en-US" sz="1000" kern="1200" dirty="0"/>
        </a:p>
      </dsp:txBody>
      <dsp:txXfrm>
        <a:off x="3673352" y="1750217"/>
        <a:ext cx="1037631" cy="996991"/>
      </dsp:txXfrm>
    </dsp:sp>
    <dsp:sp modelId="{F514985B-8F89-3E40-A9D7-AAE0741148EB}">
      <dsp:nvSpPr>
        <dsp:cNvPr id="0" name=""/>
        <dsp:cNvSpPr/>
      </dsp:nvSpPr>
      <dsp:spPr>
        <a:xfrm>
          <a:off x="3504875" y="688261"/>
          <a:ext cx="137458" cy="268939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689391"/>
              </a:lnTo>
              <a:lnTo>
                <a:pt x="137458" y="2689391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8F3191D-4F4C-B346-9CC0-DE14BF92C87E}">
      <dsp:nvSpPr>
        <dsp:cNvPr id="0" name=""/>
        <dsp:cNvSpPr/>
      </dsp:nvSpPr>
      <dsp:spPr>
        <a:xfrm>
          <a:off x="3642334" y="2950050"/>
          <a:ext cx="1099667" cy="855204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c. Any up front costs for technology.  Information from program records.  </a:t>
          </a:r>
          <a:endParaRPr lang="en-US" sz="1000" kern="1200" dirty="0"/>
        </a:p>
      </dsp:txBody>
      <dsp:txXfrm>
        <a:off x="3667382" y="2975098"/>
        <a:ext cx="1049571" cy="805108"/>
      </dsp:txXfrm>
    </dsp:sp>
    <dsp:sp modelId="{64A67B95-88B5-D945-A704-EC2CA0DBD6D0}">
      <dsp:nvSpPr>
        <dsp:cNvPr id="0" name=""/>
        <dsp:cNvSpPr/>
      </dsp:nvSpPr>
      <dsp:spPr>
        <a:xfrm>
          <a:off x="3504875" y="688261"/>
          <a:ext cx="137458" cy="386165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861650"/>
              </a:lnTo>
              <a:lnTo>
                <a:pt x="137458" y="3861650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DDB4C29-ED3F-EF44-8E3E-8512077A4EE2}">
      <dsp:nvSpPr>
        <dsp:cNvPr id="0" name=""/>
        <dsp:cNvSpPr/>
      </dsp:nvSpPr>
      <dsp:spPr>
        <a:xfrm>
          <a:off x="3642334" y="3977077"/>
          <a:ext cx="2395075" cy="114566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d. MM and/or supervisor supplies. Information from program records.  </a:t>
          </a:r>
          <a:endParaRPr lang="en-US" sz="1000" kern="1200" dirty="0"/>
        </a:p>
      </dsp:txBody>
      <dsp:txXfrm>
        <a:off x="3675889" y="4010632"/>
        <a:ext cx="2327965" cy="1078557"/>
      </dsp:txXfrm>
    </dsp:sp>
    <dsp:sp modelId="{B7EF5D09-D349-7747-B40E-22C22407BDA5}">
      <dsp:nvSpPr>
        <dsp:cNvPr id="0" name=""/>
        <dsp:cNvSpPr/>
      </dsp:nvSpPr>
      <dsp:spPr>
        <a:xfrm>
          <a:off x="3504875" y="688261"/>
          <a:ext cx="137458" cy="494995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4949953"/>
              </a:lnTo>
              <a:lnTo>
                <a:pt x="137458" y="4949953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D8DDBCB-1F4F-F841-9C74-8CDAB5C7900A}">
      <dsp:nvSpPr>
        <dsp:cNvPr id="0" name=""/>
        <dsp:cNvSpPr/>
      </dsp:nvSpPr>
      <dsp:spPr>
        <a:xfrm>
          <a:off x="3642334" y="5294568"/>
          <a:ext cx="2523835" cy="68729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e. MM and supervisor labor and any additional supplies/activities not included above.  Information from program records.</a:t>
          </a:r>
          <a:endParaRPr lang="en-US" sz="1000" kern="1200" dirty="0"/>
        </a:p>
      </dsp:txBody>
      <dsp:txXfrm>
        <a:off x="3662464" y="5314698"/>
        <a:ext cx="2483575" cy="647032"/>
      </dsp:txXfrm>
    </dsp:sp>
    <dsp:sp modelId="{18D50664-5D57-6B47-A4A5-3F64BC291717}">
      <dsp:nvSpPr>
        <dsp:cNvPr id="0" name=""/>
        <dsp:cNvSpPr/>
      </dsp:nvSpPr>
      <dsp:spPr>
        <a:xfrm>
          <a:off x="5085647" y="969"/>
          <a:ext cx="1374584" cy="687292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3. Create final costing database </a:t>
          </a:r>
          <a:endParaRPr lang="en-US" sz="1400" kern="1200" dirty="0">
            <a:solidFill>
              <a:schemeClr val="tx1"/>
            </a:solidFill>
          </a:endParaRPr>
        </a:p>
      </dsp:txBody>
      <dsp:txXfrm>
        <a:off x="5105777" y="21099"/>
        <a:ext cx="1334324" cy="647032"/>
      </dsp:txXfrm>
    </dsp:sp>
    <dsp:sp modelId="{B2B91806-4CB7-A746-ACF8-87694383FD77}">
      <dsp:nvSpPr>
        <dsp:cNvPr id="0" name=""/>
        <dsp:cNvSpPr/>
      </dsp:nvSpPr>
      <dsp:spPr>
        <a:xfrm>
          <a:off x="5223106" y="688261"/>
          <a:ext cx="137458" cy="114460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144609"/>
              </a:lnTo>
              <a:lnTo>
                <a:pt x="137458" y="1144609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6F559FE-7689-D241-90F8-CE83E7A71DC9}">
      <dsp:nvSpPr>
        <dsp:cNvPr id="0" name=""/>
        <dsp:cNvSpPr/>
      </dsp:nvSpPr>
      <dsp:spPr>
        <a:xfrm>
          <a:off x="5360564" y="860084"/>
          <a:ext cx="1099667" cy="194557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1. Data/information organized in Excel workbook to estimate cost per activity identified in Step 1/2.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 dirty="0" smtClean="0"/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With 12 sites (6 intervention/6 control), will have 12 Excel workbooks)</a:t>
          </a:r>
          <a:endParaRPr lang="en-US" sz="1000" kern="1200" dirty="0"/>
        </a:p>
      </dsp:txBody>
      <dsp:txXfrm>
        <a:off x="5392772" y="892292"/>
        <a:ext cx="1035251" cy="1881156"/>
      </dsp:txXfrm>
    </dsp:sp>
    <dsp:sp modelId="{DD58C3A6-B726-9540-84D9-6F2B86F9B425}">
      <dsp:nvSpPr>
        <dsp:cNvPr id="0" name=""/>
        <dsp:cNvSpPr/>
      </dsp:nvSpPr>
      <dsp:spPr>
        <a:xfrm>
          <a:off x="6803878" y="969"/>
          <a:ext cx="1374584" cy="687292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4. Summarize results </a:t>
          </a:r>
          <a:endParaRPr lang="en-US" sz="1400" kern="1200" dirty="0">
            <a:solidFill>
              <a:schemeClr val="tx1"/>
            </a:solidFill>
          </a:endParaRPr>
        </a:p>
      </dsp:txBody>
      <dsp:txXfrm>
        <a:off x="6824008" y="21099"/>
        <a:ext cx="1334324" cy="647032"/>
      </dsp:txXfrm>
    </dsp:sp>
    <dsp:sp modelId="{1764CA4D-9235-704F-926A-D0F9F581EF23}">
      <dsp:nvSpPr>
        <dsp:cNvPr id="0" name=""/>
        <dsp:cNvSpPr/>
      </dsp:nvSpPr>
      <dsp:spPr>
        <a:xfrm>
          <a:off x="6941336" y="688261"/>
          <a:ext cx="99365" cy="214254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142547"/>
              </a:lnTo>
              <a:lnTo>
                <a:pt x="99365" y="2142547"/>
              </a:lnTo>
            </a:path>
          </a:pathLst>
        </a:custGeom>
        <a:noFill/>
        <a:ln w="9525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43E91C6-4642-A14C-8D93-8F668859FEFB}">
      <dsp:nvSpPr>
        <dsp:cNvPr id="0" name=""/>
        <dsp:cNvSpPr/>
      </dsp:nvSpPr>
      <dsp:spPr>
        <a:xfrm>
          <a:off x="7040702" y="923583"/>
          <a:ext cx="1099667" cy="3814450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050" tIns="12700" rIns="19050" bIns="12700" numCol="1" spcCol="1270" anchor="ctr" anchorCtr="0">
          <a:noAutofit/>
        </a:bodyPr>
        <a:lstStyle/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1. Costs per activity (note: units for each activity not identical) for each site.</a:t>
          </a:r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 dirty="0" smtClean="0"/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2. Estimated average cost per activity for sites in each study arm.</a:t>
          </a:r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 dirty="0" smtClean="0"/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3.  Estimated difference in average costs for two study arms.</a:t>
          </a:r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 dirty="0" smtClean="0"/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/>
            <a:t>4.  Results from 3 above is the incremental cost of implementing the EMMMA intervention.</a:t>
          </a:r>
        </a:p>
        <a:p>
          <a:pPr lvl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 dirty="0" smtClean="0"/>
        </a:p>
      </dsp:txBody>
      <dsp:txXfrm>
        <a:off x="7072910" y="955791"/>
        <a:ext cx="1035251" cy="375003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3">
  <dgm:title val=""/>
  <dgm:desc val=""/>
  <dgm:catLst>
    <dgm:cat type="hierarchy" pri="7000"/>
    <dgm:cat type="list" pri="23000"/>
    <dgm:cat type="relationship" pri="15000"/>
    <dgm:cat type="convert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1" destId="11" srcOrd="0" destOrd="0"/>
        <dgm:cxn modelId="6" srcId="1" destId="12" srcOrd="1" destOrd="0"/>
        <dgm:cxn modelId="7" srcId="0" destId="2" srcOrd="1" destOrd="0"/>
        <dgm:cxn modelId="8" srcId="2" destId="21" srcOrd="0" destOrd="0"/>
        <dgm:cxn modelId="9" srcId="2" destId="2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forName="rootText" op="equ" val="65"/>
      <dgm:constr type="primFontSz" for="des" forName="childText" op="equ" val="65"/>
      <dgm:constr type="w" for="des" forName="rootComposite" refType="w"/>
      <dgm:constr type="h" for="des" forName="rootComposite" refType="w" fact="0.5"/>
      <dgm:constr type="w" for="des" forName="childText" refType="w" refFor="des" refForName="rootComposite" fact="0.8"/>
      <dgm:constr type="h" for="des" forName="childText" refType="h" refFor="des" refForName="rootComposite"/>
      <dgm:constr type="sibSp" refType="w" refFor="des" refForName="rootComposite" fact="0.25"/>
      <dgm:constr type="sibSp" for="des" forName="childShape" refType="h" refFor="des" refForName="childText" fact="0.25"/>
      <dgm:constr type="sp" for="des" forName="root" refType="h" refFor="des" refForName="childText" fact="0.25"/>
    </dgm:constrLst>
    <dgm:ruleLst/>
    <dgm:forEach name="Name3" axis="ch">
      <dgm:forEach name="Name4" axis="self" ptType="node" cnt="1">
        <dgm:layoutNode name="root">
          <dgm:choose name="Name5">
            <dgm:if name="Name6" func="var" arg="dir" op="equ" val="norm">
              <dgm:alg type="hierRoot">
                <dgm:param type="hierAlign" val="tL"/>
              </dgm:alg>
            </dgm:if>
            <dgm:else name="Name7">
              <dgm:alg type="hierRoot">
                <dgm:param type="hierAlign" val="tR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>
            <dgm:constr type="alignOff" val="0.2"/>
          </dgm:constrLst>
          <dgm:ruleLst/>
          <dgm:layoutNode name="rootComposite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8">
              <dgm:if name="Name9" func="var" arg="dir" op="equ" val="norm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l" for="ch" forName="rootConnector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if>
              <dgm:else name="Name10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r" for="ch" forName="rootConnector" refType="w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else>
            </dgm:choose>
            <dgm:ruleLst/>
            <dgm:layoutNode name="rootText" styleLbl="node1"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 ptType="node" cnt="1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rootConnector" moveWith="rootText">
              <dgm:alg type="sp"/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self" ptType="node" cnt="1"/>
              <dgm:constrLst/>
              <dgm:ruleLst/>
            </dgm:layoutNode>
          </dgm:layoutNode>
          <dgm:layoutNode name="childShape">
            <dgm:alg type="hierChild">
              <dgm:param type="chAlign" val="l"/>
              <dgm:param type="linDir" val="fromT"/>
            </dgm:alg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11" axis="ch">
              <dgm:forEach name="Name12" axis="self" ptType="parTrans" cnt="1">
                <dgm:layoutNode name="Name13">
                  <dgm:choose name="Name14">
                    <dgm:if name="Name15" func="var" arg="dir" op="equ" val="norm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L"/>
                      </dgm:alg>
                    </dgm:if>
                    <dgm:else name="Name16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7" axis="self" ptType="node">
                <dgm:layoutNode name="childText" styleLbl="bgAcc1">
                  <dgm:varLst>
                    <dgm:bulletEnabled val="1"/>
                  </dgm:varLst>
                  <dgm:alg type="tx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self desOrSelf" ptType="node node" st="1 1" cnt="1 0"/>
                  <dgm:constrLst>
                    <dgm:constr type="tMarg" refType="primFontSz" fact="0.1"/>
                    <dgm:constr type="bMarg" refType="primFontSz" fact="0.1"/>
                    <dgm:constr type="lMarg" refType="primFontSz" fact="0.15"/>
                    <dgm:constr type="rMarg" refType="primFontSz" fact="0.15"/>
                  </dgm:constrLst>
                  <dgm:ruleLst>
                    <dgm:rule type="primFontSz" val="5" fact="NaN" max="NaN"/>
                  </dgm:ruleLst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5157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7366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92340" y="311257"/>
            <a:ext cx="2263140" cy="66317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311257"/>
            <a:ext cx="6621780" cy="66317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4054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4642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0778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813561"/>
            <a:ext cx="4442460" cy="5129425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3020" y="1813561"/>
            <a:ext cx="4442460" cy="5129425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8437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29" y="1739795"/>
            <a:ext cx="4445953" cy="72506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29" y="2464859"/>
            <a:ext cx="4445953" cy="4478126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367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0184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5777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1" y="309457"/>
            <a:ext cx="3309144" cy="131699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5" y="309457"/>
            <a:ext cx="5622926" cy="6633528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1" y="1626447"/>
            <a:ext cx="3309144" cy="5316538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2680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8"/>
            <a:ext cx="6035040" cy="46634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3122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1"/>
            <a:ext cx="9052560" cy="5129425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4"/>
            <a:ext cx="2346960" cy="413808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E2F21-9FDF-354B-8829-E1911CD2CB74}" type="datetimeFigureOut">
              <a:rPr lang="en-US" smtClean="0"/>
              <a:t>7/11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4"/>
            <a:ext cx="3185160" cy="413808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4"/>
            <a:ext cx="2346960" cy="413808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AA475-A7AC-414C-A28F-AEE17ED69F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7723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09412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509412" rtl="0" eaLnBrk="1" latinLnBrk="0" hangingPunct="1">
        <a:spcBef>
          <a:spcPct val="20000"/>
        </a:spcBef>
        <a:buFont typeface="Arial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509412" rtl="0" eaLnBrk="1" latinLnBrk="0" hangingPunct="1">
        <a:spcBef>
          <a:spcPct val="20000"/>
        </a:spcBef>
        <a:buFont typeface="Arial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509412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509412" rtl="0" eaLnBrk="1" latinLnBrk="0" hangingPunct="1">
        <a:spcBef>
          <a:spcPct val="20000"/>
        </a:spcBef>
        <a:buFont typeface="Arial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509412" rtl="0" eaLnBrk="1" latinLnBrk="0" hangingPunct="1">
        <a:spcBef>
          <a:spcPct val="20000"/>
        </a:spcBef>
        <a:buFont typeface="Arial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509412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509412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649639"/>
          </a:xfrm>
        </p:spPr>
        <p:txBody>
          <a:bodyPr>
            <a:normAutofit fontScale="90000"/>
          </a:bodyPr>
          <a:lstStyle/>
          <a:p>
            <a:r>
              <a:rPr lang="en-US" sz="2400" b="1" smtClean="0"/>
              <a:t>EMMA Cost </a:t>
            </a:r>
            <a:r>
              <a:rPr lang="en-US" sz="2400" b="1" dirty="0" smtClean="0"/>
              <a:t>Analysis Flow Chart</a:t>
            </a:r>
            <a:br>
              <a:rPr lang="en-US" sz="2400" b="1" dirty="0" smtClean="0"/>
            </a:br>
            <a:r>
              <a:rPr lang="en-US" sz="2400" b="1" dirty="0" smtClean="0"/>
              <a:t>Objective: Estimate incremental cost of implementing EMMA intervention</a:t>
            </a:r>
            <a:endParaRPr lang="en-US" sz="2400" b="1" dirty="0"/>
          </a:p>
        </p:txBody>
      </p:sp>
      <p:graphicFrame>
        <p:nvGraphicFramePr>
          <p:cNvPr id="8" name="Content Placeholder 7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10004619"/>
              </p:ext>
            </p:extLst>
          </p:nvPr>
        </p:nvGraphicFramePr>
        <p:xfrm>
          <a:off x="274320" y="1519182"/>
          <a:ext cx="9051925" cy="598283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7271179"/>
            <a:ext cx="3292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V 465/WRAIR #2330/KEMRI 0026/3246/BUMC # </a:t>
            </a:r>
          </a:p>
          <a:p>
            <a:r>
              <a:rPr lang="en-US" sz="1200" dirty="0" smtClean="0"/>
              <a:t>Version 1.1 dated 25 April 2016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57814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32</TotalTime>
  <Words>296</Words>
  <Application>Microsoft Macintosh PowerPoint</Application>
  <PresentationFormat>Custom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EMMA Cost Analysis Flow Chart Objective: Estimate incremental cost of implementing EMMA interven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ce Larson</dc:creator>
  <cp:lastModifiedBy>Steve Schech</cp:lastModifiedBy>
  <cp:revision>40</cp:revision>
  <dcterms:created xsi:type="dcterms:W3CDTF">2015-11-24T14:38:46Z</dcterms:created>
  <dcterms:modified xsi:type="dcterms:W3CDTF">2016-07-11T14:54:58Z</dcterms:modified>
</cp:coreProperties>
</file>